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6600"/>
    <a:srgbClr val="33CCCC"/>
    <a:srgbClr val="666699"/>
    <a:srgbClr val="FFCC00"/>
    <a:srgbClr val="B2B2B2"/>
    <a:srgbClr val="CCECFF"/>
    <a:srgbClr val="6600FF"/>
    <a:srgbClr val="33CC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25" autoAdjust="0"/>
    <p:restoredTop sz="94660"/>
  </p:normalViewPr>
  <p:slideViewPr>
    <p:cSldViewPr snapToGrid="0">
      <p:cViewPr varScale="1">
        <p:scale>
          <a:sx n="119" d="100"/>
          <a:sy n="119" d="100"/>
        </p:scale>
        <p:origin x="96" y="4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827A47A-E814-4010-BD05-43290BC80A27}" type="datetimeFigureOut">
              <a:rPr lang="zh-CN" altLang="en-US" smtClean="0"/>
              <a:t>2022/10/20</a:t>
            </a:fld>
            <a:endParaRPr lang="zh-CN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33C7D7A-B501-47A4-B901-5D3CB2A0EBCB}" type="slidenum">
              <a:rPr lang="zh-CN" altLang="en-US" smtClean="0"/>
              <a:t>‹Nr.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850077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AFF07-542F-44F0-8771-4F0102133F70}" type="datetimeFigureOut">
              <a:rPr lang="de-DE" smtClean="0"/>
              <a:t>20.10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03CEE-85B1-442E-9D70-71C5552ED30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684557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AFF07-542F-44F0-8771-4F0102133F70}" type="datetimeFigureOut">
              <a:rPr lang="de-DE" smtClean="0"/>
              <a:t>20.10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03CEE-85B1-442E-9D70-71C5552ED30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68007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AFF07-542F-44F0-8771-4F0102133F70}" type="datetimeFigureOut">
              <a:rPr lang="de-DE" smtClean="0"/>
              <a:t>20.10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03CEE-85B1-442E-9D70-71C5552ED30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030139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AFF07-542F-44F0-8771-4F0102133F70}" type="datetimeFigureOut">
              <a:rPr lang="de-DE" smtClean="0"/>
              <a:t>20.10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03CEE-85B1-442E-9D70-71C5552ED30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029585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AFF07-542F-44F0-8771-4F0102133F70}" type="datetimeFigureOut">
              <a:rPr lang="de-DE" smtClean="0"/>
              <a:t>20.10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03CEE-85B1-442E-9D70-71C5552ED30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123577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AFF07-542F-44F0-8771-4F0102133F70}" type="datetimeFigureOut">
              <a:rPr lang="de-DE" smtClean="0"/>
              <a:t>20.10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03CEE-85B1-442E-9D70-71C5552ED30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417645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AFF07-542F-44F0-8771-4F0102133F70}" type="datetimeFigureOut">
              <a:rPr lang="de-DE" smtClean="0"/>
              <a:t>20.10.2022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03CEE-85B1-442E-9D70-71C5552ED30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335115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AFF07-542F-44F0-8771-4F0102133F70}" type="datetimeFigureOut">
              <a:rPr lang="de-DE" smtClean="0"/>
              <a:t>20.10.2022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03CEE-85B1-442E-9D70-71C5552ED30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264730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AFF07-542F-44F0-8771-4F0102133F70}" type="datetimeFigureOut">
              <a:rPr lang="de-DE" smtClean="0"/>
              <a:t>20.10.2022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03CEE-85B1-442E-9D70-71C5552ED30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636644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AFF07-542F-44F0-8771-4F0102133F70}" type="datetimeFigureOut">
              <a:rPr lang="de-DE" smtClean="0"/>
              <a:t>20.10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03CEE-85B1-442E-9D70-71C5552ED30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72290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AFF07-542F-44F0-8771-4F0102133F70}" type="datetimeFigureOut">
              <a:rPr lang="de-DE" smtClean="0"/>
              <a:t>20.10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03CEE-85B1-442E-9D70-71C5552ED30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614176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7AFF07-542F-44F0-8771-4F0102133F70}" type="datetimeFigureOut">
              <a:rPr lang="de-DE" smtClean="0"/>
              <a:t>20.10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603CEE-85B1-442E-9D70-71C5552ED30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719751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uppieren 5"/>
          <p:cNvGrpSpPr/>
          <p:nvPr/>
        </p:nvGrpSpPr>
        <p:grpSpPr>
          <a:xfrm>
            <a:off x="3007896" y="1457539"/>
            <a:ext cx="6355977" cy="4443693"/>
            <a:chOff x="3007896" y="1457539"/>
            <a:chExt cx="6355977" cy="4443693"/>
          </a:xfrm>
        </p:grpSpPr>
        <p:pic>
          <p:nvPicPr>
            <p:cNvPr id="115" name="Grafik 3">
              <a:extLst>
                <a:ext uri="{FF2B5EF4-FFF2-40B4-BE49-F238E27FC236}">
                  <a16:creationId xmlns:a16="http://schemas.microsoft.com/office/drawing/2014/main" xmlns="" id="{94F7F9C0-8537-FF16-44C3-8917BEA2695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423554" y="2871297"/>
              <a:ext cx="1390232" cy="2386382"/>
            </a:xfrm>
            <a:prstGeom prst="rect">
              <a:avLst/>
            </a:prstGeom>
          </p:spPr>
        </p:pic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xmlns="" id="{A7B62FF5-EBF8-9581-BA34-8BB7C982EAA5}"/>
                </a:ext>
              </a:extLst>
            </p:cNvPr>
            <p:cNvCxnSpPr>
              <a:cxnSpLocks/>
            </p:cNvCxnSpPr>
            <p:nvPr/>
          </p:nvCxnSpPr>
          <p:spPr>
            <a:xfrm>
              <a:off x="3302838" y="2564594"/>
              <a:ext cx="5810106" cy="9432"/>
            </a:xfrm>
            <a:prstGeom prst="line">
              <a:avLst/>
            </a:prstGeom>
            <a:ln w="38100">
              <a:solidFill>
                <a:schemeClr val="accent6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Connector 10">
              <a:extLst>
                <a:ext uri="{FF2B5EF4-FFF2-40B4-BE49-F238E27FC236}">
                  <a16:creationId xmlns:a16="http://schemas.microsoft.com/office/drawing/2014/main" xmlns="" id="{9BB2A271-FC05-6605-71AA-016B8A30716D}"/>
                </a:ext>
              </a:extLst>
            </p:cNvPr>
            <p:cNvCxnSpPr>
              <a:cxnSpLocks/>
            </p:cNvCxnSpPr>
            <p:nvPr/>
          </p:nvCxnSpPr>
          <p:spPr>
            <a:xfrm>
              <a:off x="3302838" y="2872889"/>
              <a:ext cx="5810106" cy="0"/>
            </a:xfrm>
            <a:prstGeom prst="line">
              <a:avLst/>
            </a:prstGeom>
            <a:ln w="38100">
              <a:solidFill>
                <a:schemeClr val="accent6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Arc 6">
              <a:extLst>
                <a:ext uri="{FF2B5EF4-FFF2-40B4-BE49-F238E27FC236}">
                  <a16:creationId xmlns:a16="http://schemas.microsoft.com/office/drawing/2014/main" xmlns="" id="{00D36611-CBDC-C413-EA07-89174BC73D99}"/>
                </a:ext>
              </a:extLst>
            </p:cNvPr>
            <p:cNvSpPr/>
            <p:nvPr/>
          </p:nvSpPr>
          <p:spPr>
            <a:xfrm rot="16200000">
              <a:off x="4419366" y="5201157"/>
              <a:ext cx="700075" cy="700075"/>
            </a:xfrm>
            <a:prstGeom prst="arc">
              <a:avLst>
                <a:gd name="adj1" fmla="val 16871440"/>
                <a:gd name="adj2" fmla="val 5232522"/>
              </a:avLst>
            </a:prstGeom>
            <a:ln w="19050">
              <a:solidFill>
                <a:schemeClr val="tx1"/>
              </a:solidFill>
              <a:headEnd type="none" w="med" len="med"/>
              <a:tailEnd type="triangl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x-none" sz="1600">
                <a:cs typeface="Arial" panose="020B0604020202020204" pitchFamily="34" charset="0"/>
              </a:endParaRPr>
            </a:p>
          </p:txBody>
        </p:sp>
        <p:sp>
          <p:nvSpPr>
            <p:cNvPr id="13" name="Rounded Rectangle 45">
              <a:extLst>
                <a:ext uri="{FF2B5EF4-FFF2-40B4-BE49-F238E27FC236}">
                  <a16:creationId xmlns:a16="http://schemas.microsoft.com/office/drawing/2014/main" xmlns="" id="{319E4B36-7872-0B22-75BD-FCE41D9C4D51}"/>
                </a:ext>
              </a:extLst>
            </p:cNvPr>
            <p:cNvSpPr/>
            <p:nvPr/>
          </p:nvSpPr>
          <p:spPr>
            <a:xfrm>
              <a:off x="7852496" y="2528147"/>
              <a:ext cx="82296" cy="566926"/>
            </a:xfrm>
            <a:prstGeom prst="roundRect">
              <a:avLst/>
            </a:prstGeom>
            <a:solidFill>
              <a:srgbClr val="FF0000"/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  <a:softEdge rad="12700"/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x-none" sz="1600">
                <a:cs typeface="Arial" panose="020B0604020202020204" pitchFamily="34" charset="0"/>
              </a:endParaRPr>
            </a:p>
          </p:txBody>
        </p:sp>
        <p:sp>
          <p:nvSpPr>
            <p:cNvPr id="15" name="Rounded Rectangle 48">
              <a:extLst>
                <a:ext uri="{FF2B5EF4-FFF2-40B4-BE49-F238E27FC236}">
                  <a16:creationId xmlns:a16="http://schemas.microsoft.com/office/drawing/2014/main" xmlns="" id="{759E0D01-12FE-9A9E-C361-F0932EE0FD15}"/>
                </a:ext>
              </a:extLst>
            </p:cNvPr>
            <p:cNvSpPr/>
            <p:nvPr/>
          </p:nvSpPr>
          <p:spPr>
            <a:xfrm flipH="1">
              <a:off x="8127217" y="2526024"/>
              <a:ext cx="82296" cy="566926"/>
            </a:xfrm>
            <a:prstGeom prst="roundRect">
              <a:avLst/>
            </a:prstGeom>
            <a:solidFill>
              <a:srgbClr val="FF0000"/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  <a:softEdge rad="12700"/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x-none" sz="1600">
                <a:cs typeface="Arial" panose="020B0604020202020204" pitchFamily="34" charset="0"/>
              </a:endParaRPr>
            </a:p>
          </p:txBody>
        </p:sp>
        <p:sp>
          <p:nvSpPr>
            <p:cNvPr id="16" name="Rounded Rectangle 41">
              <a:extLst>
                <a:ext uri="{FF2B5EF4-FFF2-40B4-BE49-F238E27FC236}">
                  <a16:creationId xmlns:a16="http://schemas.microsoft.com/office/drawing/2014/main" xmlns="" id="{8121BAAB-6A73-63F5-C7E0-6AE66016A09F}"/>
                </a:ext>
              </a:extLst>
            </p:cNvPr>
            <p:cNvSpPr/>
            <p:nvPr/>
          </p:nvSpPr>
          <p:spPr>
            <a:xfrm>
              <a:off x="7772486" y="3706384"/>
              <a:ext cx="238322" cy="402531"/>
            </a:xfrm>
            <a:prstGeom prst="roundRect">
              <a:avLst/>
            </a:prstGeom>
            <a:solidFill>
              <a:srgbClr val="FF0000"/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  <a:softEdge rad="12700"/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x-none" sz="1600">
                <a:cs typeface="Arial" panose="020B0604020202020204" pitchFamily="34" charset="0"/>
              </a:endParaRPr>
            </a:p>
          </p:txBody>
        </p:sp>
        <p:sp>
          <p:nvSpPr>
            <p:cNvPr id="17" name="Oval 16">
              <a:extLst>
                <a:ext uri="{FF2B5EF4-FFF2-40B4-BE49-F238E27FC236}">
                  <a16:creationId xmlns:a16="http://schemas.microsoft.com/office/drawing/2014/main" xmlns="" id="{9AF1C910-70BD-31E4-80A6-02C69500BD91}"/>
                </a:ext>
              </a:extLst>
            </p:cNvPr>
            <p:cNvSpPr/>
            <p:nvPr/>
          </p:nvSpPr>
          <p:spPr>
            <a:xfrm>
              <a:off x="7727976" y="2921665"/>
              <a:ext cx="321067" cy="803329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  <a:softEdge rad="12700"/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x-none" sz="1600">
                <a:cs typeface="Arial" panose="020B0604020202020204" pitchFamily="34" charset="0"/>
              </a:endParaRPr>
            </a:p>
          </p:txBody>
        </p:sp>
        <p:sp>
          <p:nvSpPr>
            <p:cNvPr id="18" name="Oval 17">
              <a:extLst>
                <a:ext uri="{FF2B5EF4-FFF2-40B4-BE49-F238E27FC236}">
                  <a16:creationId xmlns:a16="http://schemas.microsoft.com/office/drawing/2014/main" xmlns="" id="{CB99B806-A208-163E-FD9F-5018FA3CA9DE}"/>
                </a:ext>
              </a:extLst>
            </p:cNvPr>
            <p:cNvSpPr/>
            <p:nvPr/>
          </p:nvSpPr>
          <p:spPr>
            <a:xfrm>
              <a:off x="7733576" y="4083577"/>
              <a:ext cx="322326" cy="803329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  <a:softEdge rad="12700"/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x-none" sz="1600">
                <a:cs typeface="Arial" panose="020B0604020202020204" pitchFamily="34" charset="0"/>
              </a:endParaRPr>
            </a:p>
          </p:txBody>
        </p:sp>
        <p:sp>
          <p:nvSpPr>
            <p:cNvPr id="19" name="Rounded Rectangle 53">
              <a:extLst>
                <a:ext uri="{FF2B5EF4-FFF2-40B4-BE49-F238E27FC236}">
                  <a16:creationId xmlns:a16="http://schemas.microsoft.com/office/drawing/2014/main" xmlns="" id="{286B9F9D-E304-28CD-8741-3AF1074AAF64}"/>
                </a:ext>
              </a:extLst>
            </p:cNvPr>
            <p:cNvSpPr/>
            <p:nvPr/>
          </p:nvSpPr>
          <p:spPr>
            <a:xfrm>
              <a:off x="8045952" y="3711866"/>
              <a:ext cx="238322" cy="402531"/>
            </a:xfrm>
            <a:prstGeom prst="roundRect">
              <a:avLst/>
            </a:prstGeom>
            <a:solidFill>
              <a:srgbClr val="FF0000"/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  <a:softEdge rad="12700"/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x-none" sz="1600">
                <a:cs typeface="Arial" panose="020B0604020202020204" pitchFamily="34" charset="0"/>
              </a:endParaRPr>
            </a:p>
          </p:txBody>
        </p:sp>
        <p:sp>
          <p:nvSpPr>
            <p:cNvPr id="20" name="Oval 19">
              <a:extLst>
                <a:ext uri="{FF2B5EF4-FFF2-40B4-BE49-F238E27FC236}">
                  <a16:creationId xmlns:a16="http://schemas.microsoft.com/office/drawing/2014/main" xmlns="" id="{E09503D2-88BB-B659-4ADE-1E9C0D31D7EB}"/>
                </a:ext>
              </a:extLst>
            </p:cNvPr>
            <p:cNvSpPr/>
            <p:nvPr/>
          </p:nvSpPr>
          <p:spPr>
            <a:xfrm>
              <a:off x="8001442" y="2919126"/>
              <a:ext cx="321067" cy="803329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  <a:softEdge rad="12700"/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x-none" sz="1600">
                <a:cs typeface="Arial" panose="020B0604020202020204" pitchFamily="34" charset="0"/>
              </a:endParaRPr>
            </a:p>
          </p:txBody>
        </p:sp>
        <p:cxnSp>
          <p:nvCxnSpPr>
            <p:cNvPr id="23" name="Straight Connector 22">
              <a:extLst>
                <a:ext uri="{FF2B5EF4-FFF2-40B4-BE49-F238E27FC236}">
                  <a16:creationId xmlns:a16="http://schemas.microsoft.com/office/drawing/2014/main" xmlns="" id="{3BB6D694-25F0-0CA0-05EC-EB235A75705C}"/>
                </a:ext>
              </a:extLst>
            </p:cNvPr>
            <p:cNvCxnSpPr>
              <a:cxnSpLocks/>
            </p:cNvCxnSpPr>
            <p:nvPr/>
          </p:nvCxnSpPr>
          <p:spPr>
            <a:xfrm>
              <a:off x="8322509" y="2665113"/>
              <a:ext cx="0" cy="145404"/>
            </a:xfrm>
            <a:prstGeom prst="line">
              <a:avLst/>
            </a:prstGeom>
            <a:ln w="38100">
              <a:solidFill>
                <a:srgbClr val="95C11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>
              <a:extLst>
                <a:ext uri="{FF2B5EF4-FFF2-40B4-BE49-F238E27FC236}">
                  <a16:creationId xmlns:a16="http://schemas.microsoft.com/office/drawing/2014/main" xmlns="" id="{9CED6961-FEED-C0B0-1093-CF2D30AF7AAF}"/>
                </a:ext>
              </a:extLst>
            </p:cNvPr>
            <p:cNvCxnSpPr>
              <a:cxnSpLocks/>
            </p:cNvCxnSpPr>
            <p:nvPr/>
          </p:nvCxnSpPr>
          <p:spPr>
            <a:xfrm>
              <a:off x="8498721" y="2667898"/>
              <a:ext cx="0" cy="145404"/>
            </a:xfrm>
            <a:prstGeom prst="line">
              <a:avLst/>
            </a:prstGeom>
            <a:ln w="38100">
              <a:solidFill>
                <a:srgbClr val="95C11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Connector 25">
              <a:extLst>
                <a:ext uri="{FF2B5EF4-FFF2-40B4-BE49-F238E27FC236}">
                  <a16:creationId xmlns:a16="http://schemas.microsoft.com/office/drawing/2014/main" xmlns="" id="{76F77AC4-7C7C-ED14-DAD8-C86876EB0C00}"/>
                </a:ext>
              </a:extLst>
            </p:cNvPr>
            <p:cNvCxnSpPr>
              <a:cxnSpLocks/>
            </p:cNvCxnSpPr>
            <p:nvPr/>
          </p:nvCxnSpPr>
          <p:spPr>
            <a:xfrm>
              <a:off x="5714559" y="2657666"/>
              <a:ext cx="0" cy="145404"/>
            </a:xfrm>
            <a:prstGeom prst="line">
              <a:avLst/>
            </a:prstGeom>
            <a:ln w="38100">
              <a:solidFill>
                <a:srgbClr val="95C11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Connector 26">
              <a:extLst>
                <a:ext uri="{FF2B5EF4-FFF2-40B4-BE49-F238E27FC236}">
                  <a16:creationId xmlns:a16="http://schemas.microsoft.com/office/drawing/2014/main" xmlns="" id="{59360836-3378-47BF-21EC-D30C63091E4D}"/>
                </a:ext>
              </a:extLst>
            </p:cNvPr>
            <p:cNvCxnSpPr>
              <a:cxnSpLocks/>
            </p:cNvCxnSpPr>
            <p:nvPr/>
          </p:nvCxnSpPr>
          <p:spPr>
            <a:xfrm>
              <a:off x="5786749" y="2657666"/>
              <a:ext cx="0" cy="145404"/>
            </a:xfrm>
            <a:prstGeom prst="line">
              <a:avLst/>
            </a:prstGeom>
            <a:ln w="38100">
              <a:solidFill>
                <a:srgbClr val="95C11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Connector 27">
              <a:extLst>
                <a:ext uri="{FF2B5EF4-FFF2-40B4-BE49-F238E27FC236}">
                  <a16:creationId xmlns:a16="http://schemas.microsoft.com/office/drawing/2014/main" xmlns="" id="{A28C8917-20C5-43D2-8DC3-1A6EC309D827}"/>
                </a:ext>
              </a:extLst>
            </p:cNvPr>
            <p:cNvCxnSpPr>
              <a:cxnSpLocks/>
            </p:cNvCxnSpPr>
            <p:nvPr/>
          </p:nvCxnSpPr>
          <p:spPr>
            <a:xfrm>
              <a:off x="5939149" y="2657666"/>
              <a:ext cx="0" cy="145404"/>
            </a:xfrm>
            <a:prstGeom prst="line">
              <a:avLst/>
            </a:prstGeom>
            <a:ln w="38100">
              <a:solidFill>
                <a:srgbClr val="95C11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Connector 28">
              <a:extLst>
                <a:ext uri="{FF2B5EF4-FFF2-40B4-BE49-F238E27FC236}">
                  <a16:creationId xmlns:a16="http://schemas.microsoft.com/office/drawing/2014/main" xmlns="" id="{09AA4C0F-02F0-8268-7B49-0A46C95EFB56}"/>
                </a:ext>
              </a:extLst>
            </p:cNvPr>
            <p:cNvCxnSpPr>
              <a:cxnSpLocks/>
            </p:cNvCxnSpPr>
            <p:nvPr/>
          </p:nvCxnSpPr>
          <p:spPr>
            <a:xfrm>
              <a:off x="6115612" y="2658770"/>
              <a:ext cx="0" cy="145404"/>
            </a:xfrm>
            <a:prstGeom prst="line">
              <a:avLst/>
            </a:prstGeom>
            <a:ln w="38100">
              <a:solidFill>
                <a:srgbClr val="95C11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>
              <a:extLst>
                <a:ext uri="{FF2B5EF4-FFF2-40B4-BE49-F238E27FC236}">
                  <a16:creationId xmlns:a16="http://schemas.microsoft.com/office/drawing/2014/main" xmlns="" id="{43DB1FC6-C377-E101-E1C8-9A5B05002608}"/>
                </a:ext>
              </a:extLst>
            </p:cNvPr>
            <p:cNvCxnSpPr>
              <a:cxnSpLocks/>
            </p:cNvCxnSpPr>
            <p:nvPr/>
          </p:nvCxnSpPr>
          <p:spPr>
            <a:xfrm>
              <a:off x="8866305" y="2671852"/>
              <a:ext cx="0" cy="145404"/>
            </a:xfrm>
            <a:prstGeom prst="line">
              <a:avLst/>
            </a:prstGeom>
            <a:ln w="38100">
              <a:solidFill>
                <a:srgbClr val="95C11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Connector 30">
              <a:extLst>
                <a:ext uri="{FF2B5EF4-FFF2-40B4-BE49-F238E27FC236}">
                  <a16:creationId xmlns:a16="http://schemas.microsoft.com/office/drawing/2014/main" xmlns="" id="{3763FB76-6B39-CD47-6546-D8F08C6843B4}"/>
                </a:ext>
              </a:extLst>
            </p:cNvPr>
            <p:cNvCxnSpPr>
              <a:cxnSpLocks/>
            </p:cNvCxnSpPr>
            <p:nvPr/>
          </p:nvCxnSpPr>
          <p:spPr>
            <a:xfrm>
              <a:off x="8001442" y="2665113"/>
              <a:ext cx="0" cy="145404"/>
            </a:xfrm>
            <a:prstGeom prst="line">
              <a:avLst/>
            </a:prstGeom>
            <a:ln w="38100">
              <a:solidFill>
                <a:srgbClr val="95C11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Connector 31">
              <a:extLst>
                <a:ext uri="{FF2B5EF4-FFF2-40B4-BE49-F238E27FC236}">
                  <a16:creationId xmlns:a16="http://schemas.microsoft.com/office/drawing/2014/main" xmlns="" id="{28BFC6EB-7C3A-5495-7F74-296D135F919F}"/>
                </a:ext>
              </a:extLst>
            </p:cNvPr>
            <p:cNvCxnSpPr>
              <a:cxnSpLocks/>
            </p:cNvCxnSpPr>
            <p:nvPr/>
          </p:nvCxnSpPr>
          <p:spPr>
            <a:xfrm>
              <a:off x="7819856" y="2665113"/>
              <a:ext cx="0" cy="145404"/>
            </a:xfrm>
            <a:prstGeom prst="line">
              <a:avLst/>
            </a:prstGeom>
            <a:ln w="38100">
              <a:solidFill>
                <a:srgbClr val="95C11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Rounded Rectangle 139">
              <a:extLst>
                <a:ext uri="{FF2B5EF4-FFF2-40B4-BE49-F238E27FC236}">
                  <a16:creationId xmlns:a16="http://schemas.microsoft.com/office/drawing/2014/main" xmlns="" id="{2F048FDF-28A8-BB29-4F76-43B0BE730BD4}"/>
                </a:ext>
              </a:extLst>
            </p:cNvPr>
            <p:cNvSpPr/>
            <p:nvPr/>
          </p:nvSpPr>
          <p:spPr>
            <a:xfrm>
              <a:off x="4573406" y="2528147"/>
              <a:ext cx="82296" cy="566926"/>
            </a:xfrm>
            <a:prstGeom prst="roundRect">
              <a:avLst/>
            </a:prstGeom>
            <a:solidFill>
              <a:schemeClr val="accent1">
                <a:lumMod val="75000"/>
              </a:schemeClr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  <a:softEdge rad="12700"/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x-none" sz="1600">
                <a:cs typeface="Arial" panose="020B0604020202020204" pitchFamily="34" charset="0"/>
              </a:endParaRPr>
            </a:p>
          </p:txBody>
        </p:sp>
        <p:sp>
          <p:nvSpPr>
            <p:cNvPr id="48" name="Pie 140">
              <a:extLst>
                <a:ext uri="{FF2B5EF4-FFF2-40B4-BE49-F238E27FC236}">
                  <a16:creationId xmlns:a16="http://schemas.microsoft.com/office/drawing/2014/main" xmlns="" id="{B5E33A89-6B73-A80E-78A7-6A2372BBF2C6}"/>
                </a:ext>
              </a:extLst>
            </p:cNvPr>
            <p:cNvSpPr/>
            <p:nvPr/>
          </p:nvSpPr>
          <p:spPr>
            <a:xfrm rot="846535" flipH="1">
              <a:off x="4789103" y="1695939"/>
              <a:ext cx="416051" cy="850819"/>
            </a:xfrm>
            <a:prstGeom prst="pie">
              <a:avLst/>
            </a:prstGeom>
            <a:solidFill>
              <a:schemeClr val="accent1">
                <a:lumMod val="75000"/>
              </a:schemeClr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  <a:softEdge rad="12700"/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x-none" sz="1600">
                <a:cs typeface="Arial" panose="020B0604020202020204" pitchFamily="34" charset="0"/>
              </a:endParaRPr>
            </a:p>
          </p:txBody>
        </p:sp>
        <p:sp>
          <p:nvSpPr>
            <p:cNvPr id="49" name="Rounded Rectangle 141">
              <a:extLst>
                <a:ext uri="{FF2B5EF4-FFF2-40B4-BE49-F238E27FC236}">
                  <a16:creationId xmlns:a16="http://schemas.microsoft.com/office/drawing/2014/main" xmlns="" id="{1E5F3DF6-FA9A-522A-DB38-DC2F07C2C5FE}"/>
                </a:ext>
              </a:extLst>
            </p:cNvPr>
            <p:cNvSpPr/>
            <p:nvPr/>
          </p:nvSpPr>
          <p:spPr>
            <a:xfrm flipH="1">
              <a:off x="4856884" y="2526024"/>
              <a:ext cx="82296" cy="566926"/>
            </a:xfrm>
            <a:prstGeom prst="roundRect">
              <a:avLst/>
            </a:prstGeom>
            <a:solidFill>
              <a:schemeClr val="accent1">
                <a:lumMod val="75000"/>
              </a:schemeClr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  <a:softEdge rad="12700"/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x-none" sz="1600">
                <a:cs typeface="Arial" panose="020B0604020202020204" pitchFamily="34" charset="0"/>
              </a:endParaRPr>
            </a:p>
          </p:txBody>
        </p:sp>
        <p:sp>
          <p:nvSpPr>
            <p:cNvPr id="50" name="Rounded Rectangle 142">
              <a:extLst>
                <a:ext uri="{FF2B5EF4-FFF2-40B4-BE49-F238E27FC236}">
                  <a16:creationId xmlns:a16="http://schemas.microsoft.com/office/drawing/2014/main" xmlns="" id="{99A3B640-3EED-932F-37DC-207D1B8E58E9}"/>
                </a:ext>
              </a:extLst>
            </p:cNvPr>
            <p:cNvSpPr/>
            <p:nvPr/>
          </p:nvSpPr>
          <p:spPr>
            <a:xfrm>
              <a:off x="4493396" y="3698363"/>
              <a:ext cx="238322" cy="402531"/>
            </a:xfrm>
            <a:prstGeom prst="roundRect">
              <a:avLst/>
            </a:prstGeom>
            <a:solidFill>
              <a:schemeClr val="accent1">
                <a:lumMod val="75000"/>
              </a:schemeClr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  <a:softEdge rad="12700"/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x-none" sz="1600">
                <a:cs typeface="Arial" panose="020B0604020202020204" pitchFamily="34" charset="0"/>
              </a:endParaRPr>
            </a:p>
          </p:txBody>
        </p:sp>
        <p:sp>
          <p:nvSpPr>
            <p:cNvPr id="51" name="Oval 50">
              <a:extLst>
                <a:ext uri="{FF2B5EF4-FFF2-40B4-BE49-F238E27FC236}">
                  <a16:creationId xmlns:a16="http://schemas.microsoft.com/office/drawing/2014/main" xmlns="" id="{86448D81-84E0-121C-4B52-20DA6F8D1BAE}"/>
                </a:ext>
              </a:extLst>
            </p:cNvPr>
            <p:cNvSpPr/>
            <p:nvPr/>
          </p:nvSpPr>
          <p:spPr>
            <a:xfrm>
              <a:off x="4448886" y="2921665"/>
              <a:ext cx="321067" cy="803329"/>
            </a:xfrm>
            <a:prstGeom prst="ellipse">
              <a:avLst/>
            </a:prstGeom>
            <a:solidFill>
              <a:schemeClr val="accent1">
                <a:lumMod val="75000"/>
              </a:schemeClr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  <a:softEdge rad="12700"/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x-none" sz="1600">
                <a:cs typeface="Arial" panose="020B0604020202020204" pitchFamily="34" charset="0"/>
              </a:endParaRPr>
            </a:p>
          </p:txBody>
        </p:sp>
        <p:sp>
          <p:nvSpPr>
            <p:cNvPr id="52" name="Oval 51">
              <a:extLst>
                <a:ext uri="{FF2B5EF4-FFF2-40B4-BE49-F238E27FC236}">
                  <a16:creationId xmlns:a16="http://schemas.microsoft.com/office/drawing/2014/main" xmlns="" id="{C951F7FA-9C7C-42D0-9353-6B743DB13BC4}"/>
                </a:ext>
              </a:extLst>
            </p:cNvPr>
            <p:cNvSpPr/>
            <p:nvPr/>
          </p:nvSpPr>
          <p:spPr>
            <a:xfrm>
              <a:off x="4454486" y="4067535"/>
              <a:ext cx="322326" cy="803329"/>
            </a:xfrm>
            <a:prstGeom prst="ellipse">
              <a:avLst/>
            </a:prstGeom>
            <a:solidFill>
              <a:schemeClr val="accent1">
                <a:lumMod val="75000"/>
              </a:schemeClr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  <a:softEdge rad="12700"/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x-none" sz="1600">
                <a:cs typeface="Arial" panose="020B0604020202020204" pitchFamily="34" charset="0"/>
              </a:endParaRPr>
            </a:p>
          </p:txBody>
        </p:sp>
        <p:sp>
          <p:nvSpPr>
            <p:cNvPr id="53" name="Rounded Rectangle 145">
              <a:extLst>
                <a:ext uri="{FF2B5EF4-FFF2-40B4-BE49-F238E27FC236}">
                  <a16:creationId xmlns:a16="http://schemas.microsoft.com/office/drawing/2014/main" xmlns="" id="{9D449050-DCAB-C0F9-9883-070752828C9E}"/>
                </a:ext>
              </a:extLst>
            </p:cNvPr>
            <p:cNvSpPr/>
            <p:nvPr/>
          </p:nvSpPr>
          <p:spPr>
            <a:xfrm>
              <a:off x="4775619" y="3695824"/>
              <a:ext cx="238322" cy="402531"/>
            </a:xfrm>
            <a:prstGeom prst="roundRect">
              <a:avLst/>
            </a:prstGeom>
            <a:solidFill>
              <a:schemeClr val="accent1">
                <a:lumMod val="75000"/>
              </a:schemeClr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  <a:softEdge rad="12700"/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x-none" sz="1600">
                <a:cs typeface="Arial" panose="020B0604020202020204" pitchFamily="34" charset="0"/>
              </a:endParaRPr>
            </a:p>
          </p:txBody>
        </p:sp>
        <p:sp>
          <p:nvSpPr>
            <p:cNvPr id="54" name="Oval 53">
              <a:extLst>
                <a:ext uri="{FF2B5EF4-FFF2-40B4-BE49-F238E27FC236}">
                  <a16:creationId xmlns:a16="http://schemas.microsoft.com/office/drawing/2014/main" xmlns="" id="{970BCE72-B944-0368-53C5-EE7AD1113077}"/>
                </a:ext>
              </a:extLst>
            </p:cNvPr>
            <p:cNvSpPr/>
            <p:nvPr/>
          </p:nvSpPr>
          <p:spPr>
            <a:xfrm>
              <a:off x="4731109" y="2919126"/>
              <a:ext cx="321067" cy="803329"/>
            </a:xfrm>
            <a:prstGeom prst="ellipse">
              <a:avLst/>
            </a:prstGeom>
            <a:solidFill>
              <a:schemeClr val="accent1">
                <a:lumMod val="75000"/>
              </a:schemeClr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  <a:softEdge rad="12700"/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x-none" sz="1600">
                <a:cs typeface="Arial" panose="020B0604020202020204" pitchFamily="34" charset="0"/>
              </a:endParaRPr>
            </a:p>
          </p:txBody>
        </p:sp>
        <p:sp>
          <p:nvSpPr>
            <p:cNvPr id="55" name="Oval 54">
              <a:extLst>
                <a:ext uri="{FF2B5EF4-FFF2-40B4-BE49-F238E27FC236}">
                  <a16:creationId xmlns:a16="http://schemas.microsoft.com/office/drawing/2014/main" xmlns="" id="{B0CF53EB-CF25-B738-232C-F61EC9DC92F5}"/>
                </a:ext>
              </a:extLst>
            </p:cNvPr>
            <p:cNvSpPr/>
            <p:nvPr/>
          </p:nvSpPr>
          <p:spPr>
            <a:xfrm>
              <a:off x="4736709" y="4073017"/>
              <a:ext cx="322326" cy="803329"/>
            </a:xfrm>
            <a:prstGeom prst="ellipse">
              <a:avLst/>
            </a:prstGeom>
            <a:solidFill>
              <a:schemeClr val="accent1">
                <a:lumMod val="75000"/>
              </a:schemeClr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  <a:softEdge rad="12700"/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x-none" sz="1600">
                <a:cs typeface="Arial" panose="020B0604020202020204" pitchFamily="34" charset="0"/>
              </a:endParaRPr>
            </a:p>
          </p:txBody>
        </p:sp>
        <p:sp>
          <p:nvSpPr>
            <p:cNvPr id="59" name="Pie 151">
              <a:extLst>
                <a:ext uri="{FF2B5EF4-FFF2-40B4-BE49-F238E27FC236}">
                  <a16:creationId xmlns:a16="http://schemas.microsoft.com/office/drawing/2014/main" xmlns="" id="{F0E39FB6-9135-2CB0-10DD-7428816EC5DA}"/>
                </a:ext>
              </a:extLst>
            </p:cNvPr>
            <p:cNvSpPr/>
            <p:nvPr/>
          </p:nvSpPr>
          <p:spPr>
            <a:xfrm rot="20651370">
              <a:off x="5416460" y="1712688"/>
              <a:ext cx="416052" cy="850819"/>
            </a:xfrm>
            <a:prstGeom prst="pie">
              <a:avLst/>
            </a:prstGeom>
            <a:solidFill>
              <a:schemeClr val="accent3">
                <a:lumMod val="75000"/>
              </a:schemeClr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  <a:softEdge rad="12700"/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x-none" sz="1600">
                <a:cs typeface="Arial" panose="020B0604020202020204" pitchFamily="34" charset="0"/>
              </a:endParaRPr>
            </a:p>
          </p:txBody>
        </p:sp>
        <p:sp>
          <p:nvSpPr>
            <p:cNvPr id="60" name="Rounded Rectangle 152">
              <a:extLst>
                <a:ext uri="{FF2B5EF4-FFF2-40B4-BE49-F238E27FC236}">
                  <a16:creationId xmlns:a16="http://schemas.microsoft.com/office/drawing/2014/main" xmlns="" id="{209E3D34-E8FE-35CB-7BDD-57A38B38E18F}"/>
                </a:ext>
              </a:extLst>
            </p:cNvPr>
            <p:cNvSpPr/>
            <p:nvPr/>
          </p:nvSpPr>
          <p:spPr>
            <a:xfrm>
              <a:off x="5709926" y="2520700"/>
              <a:ext cx="82296" cy="566926"/>
            </a:xfrm>
            <a:prstGeom prst="roundRect">
              <a:avLst/>
            </a:prstGeom>
            <a:solidFill>
              <a:schemeClr val="accent3">
                <a:lumMod val="75000"/>
              </a:schemeClr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  <a:softEdge rad="12700"/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x-none" sz="1600">
                <a:cs typeface="Arial" panose="020B0604020202020204" pitchFamily="34" charset="0"/>
              </a:endParaRPr>
            </a:p>
          </p:txBody>
        </p:sp>
        <p:sp>
          <p:nvSpPr>
            <p:cNvPr id="61" name="Pie 153">
              <a:extLst>
                <a:ext uri="{FF2B5EF4-FFF2-40B4-BE49-F238E27FC236}">
                  <a16:creationId xmlns:a16="http://schemas.microsoft.com/office/drawing/2014/main" xmlns="" id="{5BCB1F7A-0AF0-F10A-CAD0-D4225511E3C5}"/>
                </a:ext>
              </a:extLst>
            </p:cNvPr>
            <p:cNvSpPr/>
            <p:nvPr/>
          </p:nvSpPr>
          <p:spPr>
            <a:xfrm rot="814451" flipH="1">
              <a:off x="5911653" y="1689427"/>
              <a:ext cx="416051" cy="850819"/>
            </a:xfrm>
            <a:prstGeom prst="pie">
              <a:avLst/>
            </a:prstGeom>
            <a:solidFill>
              <a:schemeClr val="accent3">
                <a:lumMod val="75000"/>
              </a:schemeClr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  <a:softEdge rad="12700"/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x-none" sz="1600">
                <a:cs typeface="Arial" panose="020B0604020202020204" pitchFamily="34" charset="0"/>
              </a:endParaRPr>
            </a:p>
          </p:txBody>
        </p:sp>
        <p:sp>
          <p:nvSpPr>
            <p:cNvPr id="62" name="Rounded Rectangle 154">
              <a:extLst>
                <a:ext uri="{FF2B5EF4-FFF2-40B4-BE49-F238E27FC236}">
                  <a16:creationId xmlns:a16="http://schemas.microsoft.com/office/drawing/2014/main" xmlns="" id="{3FF8AD32-5BD7-E736-9F41-AA4A419DA4E5}"/>
                </a:ext>
              </a:extLst>
            </p:cNvPr>
            <p:cNvSpPr/>
            <p:nvPr/>
          </p:nvSpPr>
          <p:spPr>
            <a:xfrm flipH="1">
              <a:off x="6001057" y="2518577"/>
              <a:ext cx="82296" cy="566926"/>
            </a:xfrm>
            <a:prstGeom prst="roundRect">
              <a:avLst/>
            </a:prstGeom>
            <a:solidFill>
              <a:schemeClr val="accent3">
                <a:lumMod val="75000"/>
              </a:schemeClr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  <a:softEdge rad="12700"/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x-none" sz="1600">
                <a:cs typeface="Arial" panose="020B0604020202020204" pitchFamily="34" charset="0"/>
              </a:endParaRPr>
            </a:p>
          </p:txBody>
        </p:sp>
        <p:sp>
          <p:nvSpPr>
            <p:cNvPr id="63" name="Rounded Rectangle 155">
              <a:extLst>
                <a:ext uri="{FF2B5EF4-FFF2-40B4-BE49-F238E27FC236}">
                  <a16:creationId xmlns:a16="http://schemas.microsoft.com/office/drawing/2014/main" xmlns="" id="{9CCFBA17-E609-446B-DE0E-46A5C61C9771}"/>
                </a:ext>
              </a:extLst>
            </p:cNvPr>
            <p:cNvSpPr/>
            <p:nvPr/>
          </p:nvSpPr>
          <p:spPr>
            <a:xfrm>
              <a:off x="5629916" y="3690916"/>
              <a:ext cx="238322" cy="402531"/>
            </a:xfrm>
            <a:prstGeom prst="roundRect">
              <a:avLst/>
            </a:prstGeom>
            <a:solidFill>
              <a:schemeClr val="accent3">
                <a:lumMod val="75000"/>
              </a:schemeClr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  <a:softEdge rad="12700"/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x-none" sz="1600">
                <a:cs typeface="Arial" panose="020B0604020202020204" pitchFamily="34" charset="0"/>
              </a:endParaRPr>
            </a:p>
          </p:txBody>
        </p:sp>
        <p:sp>
          <p:nvSpPr>
            <p:cNvPr id="64" name="Oval 63">
              <a:extLst>
                <a:ext uri="{FF2B5EF4-FFF2-40B4-BE49-F238E27FC236}">
                  <a16:creationId xmlns:a16="http://schemas.microsoft.com/office/drawing/2014/main" xmlns="" id="{8A0DE59A-A88B-5733-1762-1C19D2111D19}"/>
                </a:ext>
              </a:extLst>
            </p:cNvPr>
            <p:cNvSpPr/>
            <p:nvPr/>
          </p:nvSpPr>
          <p:spPr>
            <a:xfrm>
              <a:off x="5585406" y="2914218"/>
              <a:ext cx="321067" cy="803329"/>
            </a:xfrm>
            <a:prstGeom prst="ellipse">
              <a:avLst/>
            </a:prstGeom>
            <a:solidFill>
              <a:schemeClr val="accent3">
                <a:lumMod val="75000"/>
              </a:schemeClr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  <a:softEdge rad="12700"/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x-none" sz="1600">
                <a:cs typeface="Arial" panose="020B0604020202020204" pitchFamily="34" charset="0"/>
              </a:endParaRPr>
            </a:p>
          </p:txBody>
        </p:sp>
        <p:sp>
          <p:nvSpPr>
            <p:cNvPr id="65" name="Oval 64">
              <a:extLst>
                <a:ext uri="{FF2B5EF4-FFF2-40B4-BE49-F238E27FC236}">
                  <a16:creationId xmlns:a16="http://schemas.microsoft.com/office/drawing/2014/main" xmlns="" id="{A7FADDA8-612A-81C3-FDD4-B2F38707BCDB}"/>
                </a:ext>
              </a:extLst>
            </p:cNvPr>
            <p:cNvSpPr/>
            <p:nvPr/>
          </p:nvSpPr>
          <p:spPr>
            <a:xfrm>
              <a:off x="5591006" y="4060088"/>
              <a:ext cx="322326" cy="803329"/>
            </a:xfrm>
            <a:prstGeom prst="ellipse">
              <a:avLst/>
            </a:prstGeom>
            <a:solidFill>
              <a:schemeClr val="accent3">
                <a:lumMod val="75000"/>
              </a:schemeClr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  <a:softEdge rad="12700"/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x-none" sz="1600">
                <a:cs typeface="Arial" panose="020B0604020202020204" pitchFamily="34" charset="0"/>
              </a:endParaRPr>
            </a:p>
          </p:txBody>
        </p:sp>
        <p:sp>
          <p:nvSpPr>
            <p:cNvPr id="66" name="Rounded Rectangle 158">
              <a:extLst>
                <a:ext uri="{FF2B5EF4-FFF2-40B4-BE49-F238E27FC236}">
                  <a16:creationId xmlns:a16="http://schemas.microsoft.com/office/drawing/2014/main" xmlns="" id="{3ED82A39-CF2F-CD62-07CD-1DC78A69C824}"/>
                </a:ext>
              </a:extLst>
            </p:cNvPr>
            <p:cNvSpPr/>
            <p:nvPr/>
          </p:nvSpPr>
          <p:spPr>
            <a:xfrm>
              <a:off x="5919792" y="3696398"/>
              <a:ext cx="238322" cy="402531"/>
            </a:xfrm>
            <a:prstGeom prst="roundRect">
              <a:avLst/>
            </a:prstGeom>
            <a:solidFill>
              <a:schemeClr val="accent3">
                <a:lumMod val="75000"/>
              </a:schemeClr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  <a:softEdge rad="12700"/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x-none" sz="1600">
                <a:cs typeface="Arial" panose="020B0604020202020204" pitchFamily="34" charset="0"/>
              </a:endParaRPr>
            </a:p>
          </p:txBody>
        </p:sp>
        <p:sp>
          <p:nvSpPr>
            <p:cNvPr id="67" name="Oval 66">
              <a:extLst>
                <a:ext uri="{FF2B5EF4-FFF2-40B4-BE49-F238E27FC236}">
                  <a16:creationId xmlns:a16="http://schemas.microsoft.com/office/drawing/2014/main" xmlns="" id="{4FDC190E-DA04-6459-636E-CFDED331E968}"/>
                </a:ext>
              </a:extLst>
            </p:cNvPr>
            <p:cNvSpPr/>
            <p:nvPr/>
          </p:nvSpPr>
          <p:spPr>
            <a:xfrm>
              <a:off x="5875282" y="2911679"/>
              <a:ext cx="321067" cy="803329"/>
            </a:xfrm>
            <a:prstGeom prst="ellipse">
              <a:avLst/>
            </a:prstGeom>
            <a:solidFill>
              <a:schemeClr val="accent3">
                <a:lumMod val="75000"/>
              </a:schemeClr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  <a:softEdge rad="12700"/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x-none" sz="1600">
                <a:cs typeface="Arial" panose="020B0604020202020204" pitchFamily="34" charset="0"/>
              </a:endParaRPr>
            </a:p>
          </p:txBody>
        </p:sp>
        <p:sp>
          <p:nvSpPr>
            <p:cNvPr id="68" name="Oval 67">
              <a:extLst>
                <a:ext uri="{FF2B5EF4-FFF2-40B4-BE49-F238E27FC236}">
                  <a16:creationId xmlns:a16="http://schemas.microsoft.com/office/drawing/2014/main" xmlns="" id="{CD22CC3F-56A3-A473-F409-586C8423C5C9}"/>
                </a:ext>
              </a:extLst>
            </p:cNvPr>
            <p:cNvSpPr/>
            <p:nvPr/>
          </p:nvSpPr>
          <p:spPr>
            <a:xfrm>
              <a:off x="5880882" y="4081612"/>
              <a:ext cx="322326" cy="803329"/>
            </a:xfrm>
            <a:prstGeom prst="ellipse">
              <a:avLst/>
            </a:prstGeom>
            <a:solidFill>
              <a:schemeClr val="accent3">
                <a:lumMod val="75000"/>
              </a:schemeClr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  <a:softEdge rad="12700"/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x-none" sz="1600">
                <a:cs typeface="Arial" panose="020B0604020202020204" pitchFamily="34" charset="0"/>
              </a:endParaRPr>
            </a:p>
          </p:txBody>
        </p:sp>
        <p:cxnSp>
          <p:nvCxnSpPr>
            <p:cNvPr id="69" name="Straight Connector 68">
              <a:extLst>
                <a:ext uri="{FF2B5EF4-FFF2-40B4-BE49-F238E27FC236}">
                  <a16:creationId xmlns:a16="http://schemas.microsoft.com/office/drawing/2014/main" xmlns="" id="{176ADAE9-46B0-A71E-EEB8-FA1B29C70E34}"/>
                </a:ext>
              </a:extLst>
            </p:cNvPr>
            <p:cNvCxnSpPr>
              <a:cxnSpLocks/>
            </p:cNvCxnSpPr>
            <p:nvPr/>
          </p:nvCxnSpPr>
          <p:spPr>
            <a:xfrm>
              <a:off x="5563494" y="2657666"/>
              <a:ext cx="0" cy="145404"/>
            </a:xfrm>
            <a:prstGeom prst="line">
              <a:avLst/>
            </a:prstGeom>
            <a:ln w="38100">
              <a:solidFill>
                <a:srgbClr val="95C11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Straight Connector 69">
              <a:extLst>
                <a:ext uri="{FF2B5EF4-FFF2-40B4-BE49-F238E27FC236}">
                  <a16:creationId xmlns:a16="http://schemas.microsoft.com/office/drawing/2014/main" xmlns="" id="{8A71D5D6-5618-1766-5966-17C09DC97E37}"/>
                </a:ext>
              </a:extLst>
            </p:cNvPr>
            <p:cNvCxnSpPr>
              <a:cxnSpLocks/>
            </p:cNvCxnSpPr>
            <p:nvPr/>
          </p:nvCxnSpPr>
          <p:spPr>
            <a:xfrm>
              <a:off x="5162217" y="2657666"/>
              <a:ext cx="0" cy="145404"/>
            </a:xfrm>
            <a:prstGeom prst="line">
              <a:avLst/>
            </a:prstGeom>
            <a:ln w="38100">
              <a:solidFill>
                <a:srgbClr val="95C11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Straight Connector 70">
              <a:extLst>
                <a:ext uri="{FF2B5EF4-FFF2-40B4-BE49-F238E27FC236}">
                  <a16:creationId xmlns:a16="http://schemas.microsoft.com/office/drawing/2014/main" xmlns="" id="{DFC76C14-3501-4C4A-ED13-6E07C10A2D4B}"/>
                </a:ext>
              </a:extLst>
            </p:cNvPr>
            <p:cNvCxnSpPr>
              <a:cxnSpLocks/>
            </p:cNvCxnSpPr>
            <p:nvPr/>
          </p:nvCxnSpPr>
          <p:spPr>
            <a:xfrm>
              <a:off x="5012715" y="2657666"/>
              <a:ext cx="0" cy="145404"/>
            </a:xfrm>
            <a:prstGeom prst="line">
              <a:avLst/>
            </a:prstGeom>
            <a:ln w="38100">
              <a:solidFill>
                <a:srgbClr val="95C11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Straight Connector 73">
              <a:extLst>
                <a:ext uri="{FF2B5EF4-FFF2-40B4-BE49-F238E27FC236}">
                  <a16:creationId xmlns:a16="http://schemas.microsoft.com/office/drawing/2014/main" xmlns="" id="{B9A933BF-983B-6602-A42B-147945D6418C}"/>
                </a:ext>
              </a:extLst>
            </p:cNvPr>
            <p:cNvCxnSpPr>
              <a:cxnSpLocks/>
            </p:cNvCxnSpPr>
            <p:nvPr/>
          </p:nvCxnSpPr>
          <p:spPr>
            <a:xfrm>
              <a:off x="4502531" y="2657666"/>
              <a:ext cx="0" cy="145404"/>
            </a:xfrm>
            <a:prstGeom prst="line">
              <a:avLst/>
            </a:prstGeom>
            <a:ln w="38100">
              <a:solidFill>
                <a:srgbClr val="95C11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Straight Connector 74">
              <a:extLst>
                <a:ext uri="{FF2B5EF4-FFF2-40B4-BE49-F238E27FC236}">
                  <a16:creationId xmlns:a16="http://schemas.microsoft.com/office/drawing/2014/main" xmlns="" id="{9E1BEFA8-4B83-D6D0-A6A6-CFB28AD0F2F9}"/>
                </a:ext>
              </a:extLst>
            </p:cNvPr>
            <p:cNvCxnSpPr>
              <a:cxnSpLocks/>
            </p:cNvCxnSpPr>
            <p:nvPr/>
          </p:nvCxnSpPr>
          <p:spPr>
            <a:xfrm>
              <a:off x="4662952" y="2657666"/>
              <a:ext cx="0" cy="145404"/>
            </a:xfrm>
            <a:prstGeom prst="line">
              <a:avLst/>
            </a:prstGeom>
            <a:ln w="38100">
              <a:solidFill>
                <a:srgbClr val="95C11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Straight Connector 75">
              <a:extLst>
                <a:ext uri="{FF2B5EF4-FFF2-40B4-BE49-F238E27FC236}">
                  <a16:creationId xmlns:a16="http://schemas.microsoft.com/office/drawing/2014/main" xmlns="" id="{30632E6D-3E30-6E04-0F17-8F07BC94C570}"/>
                </a:ext>
              </a:extLst>
            </p:cNvPr>
            <p:cNvCxnSpPr>
              <a:cxnSpLocks/>
            </p:cNvCxnSpPr>
            <p:nvPr/>
          </p:nvCxnSpPr>
          <p:spPr>
            <a:xfrm>
              <a:off x="4799310" y="2657666"/>
              <a:ext cx="0" cy="145404"/>
            </a:xfrm>
            <a:prstGeom prst="line">
              <a:avLst/>
            </a:prstGeom>
            <a:ln w="38100">
              <a:solidFill>
                <a:srgbClr val="95C11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Straight Connector 77">
              <a:extLst>
                <a:ext uri="{FF2B5EF4-FFF2-40B4-BE49-F238E27FC236}">
                  <a16:creationId xmlns:a16="http://schemas.microsoft.com/office/drawing/2014/main" xmlns="" id="{A49D9843-D074-2439-8C71-C1335C6079AE}"/>
                </a:ext>
              </a:extLst>
            </p:cNvPr>
            <p:cNvCxnSpPr>
              <a:cxnSpLocks/>
            </p:cNvCxnSpPr>
            <p:nvPr/>
          </p:nvCxnSpPr>
          <p:spPr>
            <a:xfrm>
              <a:off x="7713003" y="2667695"/>
              <a:ext cx="0" cy="145404"/>
            </a:xfrm>
            <a:prstGeom prst="line">
              <a:avLst/>
            </a:prstGeom>
            <a:ln w="38100">
              <a:solidFill>
                <a:srgbClr val="95C11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Straight Connector 81">
              <a:extLst>
                <a:ext uri="{FF2B5EF4-FFF2-40B4-BE49-F238E27FC236}">
                  <a16:creationId xmlns:a16="http://schemas.microsoft.com/office/drawing/2014/main" xmlns="" id="{392E932F-BE48-89EC-D907-FF08CF7CFC79}"/>
                </a:ext>
              </a:extLst>
            </p:cNvPr>
            <p:cNvCxnSpPr>
              <a:cxnSpLocks/>
            </p:cNvCxnSpPr>
            <p:nvPr/>
          </p:nvCxnSpPr>
          <p:spPr>
            <a:xfrm>
              <a:off x="8647446" y="2671852"/>
              <a:ext cx="0" cy="145404"/>
            </a:xfrm>
            <a:prstGeom prst="line">
              <a:avLst/>
            </a:prstGeom>
            <a:ln w="38100">
              <a:solidFill>
                <a:srgbClr val="95C11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xmlns="" id="{C4679A5A-0906-68E1-3C49-BD26B6FE400B}"/>
                </a:ext>
              </a:extLst>
            </p:cNvPr>
            <p:cNvSpPr txBox="1"/>
            <p:nvPr/>
          </p:nvSpPr>
          <p:spPr>
            <a:xfrm>
              <a:off x="3240376" y="2572790"/>
              <a:ext cx="123251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x-none" sz="1200" b="1" i="1" dirty="0">
                  <a:latin typeface="Calibri" panose="020F0502020204030204" pitchFamily="34" charset="0"/>
                  <a:cs typeface="Arial" panose="020B0604020202020204" pitchFamily="34" charset="0"/>
                </a:rPr>
                <a:t>Transmembrane</a:t>
              </a:r>
              <a:endParaRPr lang="x-none" sz="1600" b="1" i="1" dirty="0">
                <a:latin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xmlns="" id="{AABF061F-0284-3160-93F0-45372852908E}"/>
                </a:ext>
              </a:extLst>
            </p:cNvPr>
            <p:cNvSpPr txBox="1"/>
            <p:nvPr/>
          </p:nvSpPr>
          <p:spPr>
            <a:xfrm>
              <a:off x="8645205" y="3732964"/>
              <a:ext cx="718668" cy="307777"/>
            </a:xfrm>
            <a:custGeom>
              <a:avLst/>
              <a:gdLst>
                <a:gd name="connsiteX0" fmla="*/ 0 w 1231835"/>
                <a:gd name="connsiteY0" fmla="*/ 281315 h 562630"/>
                <a:gd name="connsiteX1" fmla="*/ 615918 w 1231835"/>
                <a:gd name="connsiteY1" fmla="*/ 0 h 562630"/>
                <a:gd name="connsiteX2" fmla="*/ 1231836 w 1231835"/>
                <a:gd name="connsiteY2" fmla="*/ 281315 h 562630"/>
                <a:gd name="connsiteX3" fmla="*/ 615918 w 1231835"/>
                <a:gd name="connsiteY3" fmla="*/ 562630 h 562630"/>
                <a:gd name="connsiteX4" fmla="*/ 0 w 1231835"/>
                <a:gd name="connsiteY4" fmla="*/ 281315 h 562630"/>
                <a:gd name="connsiteX0" fmla="*/ 7255 w 1239091"/>
                <a:gd name="connsiteY0" fmla="*/ 300770 h 582085"/>
                <a:gd name="connsiteX1" fmla="*/ 306367 w 1239091"/>
                <a:gd name="connsiteY1" fmla="*/ 54861 h 582085"/>
                <a:gd name="connsiteX2" fmla="*/ 623173 w 1239091"/>
                <a:gd name="connsiteY2" fmla="*/ 19455 h 582085"/>
                <a:gd name="connsiteX3" fmla="*/ 1239091 w 1239091"/>
                <a:gd name="connsiteY3" fmla="*/ 300770 h 582085"/>
                <a:gd name="connsiteX4" fmla="*/ 623173 w 1239091"/>
                <a:gd name="connsiteY4" fmla="*/ 582085 h 582085"/>
                <a:gd name="connsiteX5" fmla="*/ 7255 w 1239091"/>
                <a:gd name="connsiteY5" fmla="*/ 300770 h 582085"/>
                <a:gd name="connsiteX0" fmla="*/ 0 w 1231836"/>
                <a:gd name="connsiteY0" fmla="*/ 300770 h 597498"/>
                <a:gd name="connsiteX1" fmla="*/ 299112 w 1231836"/>
                <a:gd name="connsiteY1" fmla="*/ 54861 h 597498"/>
                <a:gd name="connsiteX2" fmla="*/ 615918 w 1231836"/>
                <a:gd name="connsiteY2" fmla="*/ 19455 h 597498"/>
                <a:gd name="connsiteX3" fmla="*/ 1231836 w 1231836"/>
                <a:gd name="connsiteY3" fmla="*/ 300770 h 597498"/>
                <a:gd name="connsiteX4" fmla="*/ 615918 w 1231836"/>
                <a:gd name="connsiteY4" fmla="*/ 582085 h 597498"/>
                <a:gd name="connsiteX5" fmla="*/ 299112 w 1231836"/>
                <a:gd name="connsiteY5" fmla="*/ 533034 h 597498"/>
                <a:gd name="connsiteX6" fmla="*/ 0 w 1231836"/>
                <a:gd name="connsiteY6" fmla="*/ 300770 h 597498"/>
                <a:gd name="connsiteX0" fmla="*/ 67394 w 972059"/>
                <a:gd name="connsiteY0" fmla="*/ 342715 h 597498"/>
                <a:gd name="connsiteX1" fmla="*/ 39335 w 972059"/>
                <a:gd name="connsiteY1" fmla="*/ 54861 h 597498"/>
                <a:gd name="connsiteX2" fmla="*/ 356141 w 972059"/>
                <a:gd name="connsiteY2" fmla="*/ 19455 h 597498"/>
                <a:gd name="connsiteX3" fmla="*/ 972059 w 972059"/>
                <a:gd name="connsiteY3" fmla="*/ 300770 h 597498"/>
                <a:gd name="connsiteX4" fmla="*/ 356141 w 972059"/>
                <a:gd name="connsiteY4" fmla="*/ 582085 h 597498"/>
                <a:gd name="connsiteX5" fmla="*/ 39335 w 972059"/>
                <a:gd name="connsiteY5" fmla="*/ 533034 h 597498"/>
                <a:gd name="connsiteX6" fmla="*/ 67394 w 972059"/>
                <a:gd name="connsiteY6" fmla="*/ 342715 h 597498"/>
                <a:gd name="connsiteX0" fmla="*/ 67394 w 695222"/>
                <a:gd name="connsiteY0" fmla="*/ 344579 h 597540"/>
                <a:gd name="connsiteX1" fmla="*/ 39335 w 695222"/>
                <a:gd name="connsiteY1" fmla="*/ 56725 h 597540"/>
                <a:gd name="connsiteX2" fmla="*/ 356141 w 695222"/>
                <a:gd name="connsiteY2" fmla="*/ 21319 h 597540"/>
                <a:gd name="connsiteX3" fmla="*/ 695222 w 695222"/>
                <a:gd name="connsiteY3" fmla="*/ 327801 h 597540"/>
                <a:gd name="connsiteX4" fmla="*/ 356141 w 695222"/>
                <a:gd name="connsiteY4" fmla="*/ 583949 h 597540"/>
                <a:gd name="connsiteX5" fmla="*/ 39335 w 695222"/>
                <a:gd name="connsiteY5" fmla="*/ 534898 h 597540"/>
                <a:gd name="connsiteX6" fmla="*/ 67394 w 695222"/>
                <a:gd name="connsiteY6" fmla="*/ 344579 h 597540"/>
                <a:gd name="connsiteX0" fmla="*/ 67394 w 733837"/>
                <a:gd name="connsiteY0" fmla="*/ 325122 h 578083"/>
                <a:gd name="connsiteX1" fmla="*/ 39335 w 733837"/>
                <a:gd name="connsiteY1" fmla="*/ 37268 h 578083"/>
                <a:gd name="connsiteX2" fmla="*/ 356141 w 733837"/>
                <a:gd name="connsiteY2" fmla="*/ 1862 h 578083"/>
                <a:gd name="connsiteX3" fmla="*/ 702064 w 733837"/>
                <a:gd name="connsiteY3" fmla="*/ 45657 h 578083"/>
                <a:gd name="connsiteX4" fmla="*/ 695222 w 733837"/>
                <a:gd name="connsiteY4" fmla="*/ 308344 h 578083"/>
                <a:gd name="connsiteX5" fmla="*/ 356141 w 733837"/>
                <a:gd name="connsiteY5" fmla="*/ 564492 h 578083"/>
                <a:gd name="connsiteX6" fmla="*/ 39335 w 733837"/>
                <a:gd name="connsiteY6" fmla="*/ 515441 h 578083"/>
                <a:gd name="connsiteX7" fmla="*/ 67394 w 733837"/>
                <a:gd name="connsiteY7" fmla="*/ 325122 h 578083"/>
                <a:gd name="connsiteX0" fmla="*/ 67394 w 731375"/>
                <a:gd name="connsiteY0" fmla="*/ 325122 h 580348"/>
                <a:gd name="connsiteX1" fmla="*/ 39335 w 731375"/>
                <a:gd name="connsiteY1" fmla="*/ 37268 h 580348"/>
                <a:gd name="connsiteX2" fmla="*/ 356141 w 731375"/>
                <a:gd name="connsiteY2" fmla="*/ 1862 h 580348"/>
                <a:gd name="connsiteX3" fmla="*/ 702064 w 731375"/>
                <a:gd name="connsiteY3" fmla="*/ 45657 h 580348"/>
                <a:gd name="connsiteX4" fmla="*/ 695222 w 731375"/>
                <a:gd name="connsiteY4" fmla="*/ 308344 h 580348"/>
                <a:gd name="connsiteX5" fmla="*/ 651730 w 731375"/>
                <a:gd name="connsiteY5" fmla="*/ 557385 h 580348"/>
                <a:gd name="connsiteX6" fmla="*/ 356141 w 731375"/>
                <a:gd name="connsiteY6" fmla="*/ 564492 h 580348"/>
                <a:gd name="connsiteX7" fmla="*/ 39335 w 731375"/>
                <a:gd name="connsiteY7" fmla="*/ 515441 h 580348"/>
                <a:gd name="connsiteX8" fmla="*/ 67394 w 731375"/>
                <a:gd name="connsiteY8" fmla="*/ 325122 h 580348"/>
                <a:gd name="connsiteX0" fmla="*/ 67394 w 717627"/>
                <a:gd name="connsiteY0" fmla="*/ 325122 h 580348"/>
                <a:gd name="connsiteX1" fmla="*/ 39335 w 717627"/>
                <a:gd name="connsiteY1" fmla="*/ 37268 h 580348"/>
                <a:gd name="connsiteX2" fmla="*/ 356141 w 717627"/>
                <a:gd name="connsiteY2" fmla="*/ 1862 h 580348"/>
                <a:gd name="connsiteX3" fmla="*/ 702064 w 717627"/>
                <a:gd name="connsiteY3" fmla="*/ 45657 h 580348"/>
                <a:gd name="connsiteX4" fmla="*/ 619721 w 717627"/>
                <a:gd name="connsiteY4" fmla="*/ 308344 h 580348"/>
                <a:gd name="connsiteX5" fmla="*/ 651730 w 717627"/>
                <a:gd name="connsiteY5" fmla="*/ 557385 h 580348"/>
                <a:gd name="connsiteX6" fmla="*/ 356141 w 717627"/>
                <a:gd name="connsiteY6" fmla="*/ 564492 h 580348"/>
                <a:gd name="connsiteX7" fmla="*/ 39335 w 717627"/>
                <a:gd name="connsiteY7" fmla="*/ 515441 h 580348"/>
                <a:gd name="connsiteX8" fmla="*/ 67394 w 717627"/>
                <a:gd name="connsiteY8" fmla="*/ 325122 h 580348"/>
                <a:gd name="connsiteX0" fmla="*/ 69647 w 719880"/>
                <a:gd name="connsiteY0" fmla="*/ 325122 h 593280"/>
                <a:gd name="connsiteX1" fmla="*/ 41588 w 719880"/>
                <a:gd name="connsiteY1" fmla="*/ 37268 h 593280"/>
                <a:gd name="connsiteX2" fmla="*/ 358394 w 719880"/>
                <a:gd name="connsiteY2" fmla="*/ 1862 h 593280"/>
                <a:gd name="connsiteX3" fmla="*/ 704317 w 719880"/>
                <a:gd name="connsiteY3" fmla="*/ 45657 h 593280"/>
                <a:gd name="connsiteX4" fmla="*/ 621974 w 719880"/>
                <a:gd name="connsiteY4" fmla="*/ 308344 h 593280"/>
                <a:gd name="connsiteX5" fmla="*/ 653983 w 719880"/>
                <a:gd name="connsiteY5" fmla="*/ 557385 h 593280"/>
                <a:gd name="connsiteX6" fmla="*/ 358394 w 719880"/>
                <a:gd name="connsiteY6" fmla="*/ 564492 h 593280"/>
                <a:gd name="connsiteX7" fmla="*/ 117089 w 719880"/>
                <a:gd name="connsiteY7" fmla="*/ 574164 h 593280"/>
                <a:gd name="connsiteX8" fmla="*/ 69647 w 719880"/>
                <a:gd name="connsiteY8" fmla="*/ 325122 h 593280"/>
                <a:gd name="connsiteX0" fmla="*/ 104186 w 712474"/>
                <a:gd name="connsiteY0" fmla="*/ 350289 h 593280"/>
                <a:gd name="connsiteX1" fmla="*/ 34182 w 712474"/>
                <a:gd name="connsiteY1" fmla="*/ 37268 h 593280"/>
                <a:gd name="connsiteX2" fmla="*/ 350988 w 712474"/>
                <a:gd name="connsiteY2" fmla="*/ 1862 h 593280"/>
                <a:gd name="connsiteX3" fmla="*/ 696911 w 712474"/>
                <a:gd name="connsiteY3" fmla="*/ 45657 h 593280"/>
                <a:gd name="connsiteX4" fmla="*/ 614568 w 712474"/>
                <a:gd name="connsiteY4" fmla="*/ 308344 h 593280"/>
                <a:gd name="connsiteX5" fmla="*/ 646577 w 712474"/>
                <a:gd name="connsiteY5" fmla="*/ 557385 h 593280"/>
                <a:gd name="connsiteX6" fmla="*/ 350988 w 712474"/>
                <a:gd name="connsiteY6" fmla="*/ 564492 h 593280"/>
                <a:gd name="connsiteX7" fmla="*/ 109683 w 712474"/>
                <a:gd name="connsiteY7" fmla="*/ 574164 h 593280"/>
                <a:gd name="connsiteX8" fmla="*/ 104186 w 712474"/>
                <a:gd name="connsiteY8" fmla="*/ 350289 h 593280"/>
                <a:gd name="connsiteX0" fmla="*/ 82449 w 690737"/>
                <a:gd name="connsiteY0" fmla="*/ 350289 h 593280"/>
                <a:gd name="connsiteX1" fmla="*/ 37612 w 690737"/>
                <a:gd name="connsiteY1" fmla="*/ 37268 h 593280"/>
                <a:gd name="connsiteX2" fmla="*/ 329251 w 690737"/>
                <a:gd name="connsiteY2" fmla="*/ 1862 h 593280"/>
                <a:gd name="connsiteX3" fmla="*/ 675174 w 690737"/>
                <a:gd name="connsiteY3" fmla="*/ 45657 h 593280"/>
                <a:gd name="connsiteX4" fmla="*/ 592831 w 690737"/>
                <a:gd name="connsiteY4" fmla="*/ 308344 h 593280"/>
                <a:gd name="connsiteX5" fmla="*/ 624840 w 690737"/>
                <a:gd name="connsiteY5" fmla="*/ 557385 h 593280"/>
                <a:gd name="connsiteX6" fmla="*/ 329251 w 690737"/>
                <a:gd name="connsiteY6" fmla="*/ 564492 h 593280"/>
                <a:gd name="connsiteX7" fmla="*/ 87946 w 690737"/>
                <a:gd name="connsiteY7" fmla="*/ 574164 h 593280"/>
                <a:gd name="connsiteX8" fmla="*/ 82449 w 690737"/>
                <a:gd name="connsiteY8" fmla="*/ 350289 h 593280"/>
                <a:gd name="connsiteX0" fmla="*/ 48082 w 656370"/>
                <a:gd name="connsiteY0" fmla="*/ 348786 h 591777"/>
                <a:gd name="connsiteX1" fmla="*/ 45190 w 656370"/>
                <a:gd name="connsiteY1" fmla="*/ 44154 h 591777"/>
                <a:gd name="connsiteX2" fmla="*/ 294884 w 656370"/>
                <a:gd name="connsiteY2" fmla="*/ 359 h 591777"/>
                <a:gd name="connsiteX3" fmla="*/ 640807 w 656370"/>
                <a:gd name="connsiteY3" fmla="*/ 44154 h 591777"/>
                <a:gd name="connsiteX4" fmla="*/ 558464 w 656370"/>
                <a:gd name="connsiteY4" fmla="*/ 306841 h 591777"/>
                <a:gd name="connsiteX5" fmla="*/ 590473 w 656370"/>
                <a:gd name="connsiteY5" fmla="*/ 555882 h 591777"/>
                <a:gd name="connsiteX6" fmla="*/ 294884 w 656370"/>
                <a:gd name="connsiteY6" fmla="*/ 562989 h 591777"/>
                <a:gd name="connsiteX7" fmla="*/ 53579 w 656370"/>
                <a:gd name="connsiteY7" fmla="*/ 572661 h 591777"/>
                <a:gd name="connsiteX8" fmla="*/ 48082 w 656370"/>
                <a:gd name="connsiteY8" fmla="*/ 348786 h 591777"/>
                <a:gd name="connsiteX0" fmla="*/ 48082 w 658226"/>
                <a:gd name="connsiteY0" fmla="*/ 348786 h 591777"/>
                <a:gd name="connsiteX1" fmla="*/ 45190 w 658226"/>
                <a:gd name="connsiteY1" fmla="*/ 44154 h 591777"/>
                <a:gd name="connsiteX2" fmla="*/ 294884 w 658226"/>
                <a:gd name="connsiteY2" fmla="*/ 359 h 591777"/>
                <a:gd name="connsiteX3" fmla="*/ 640807 w 658226"/>
                <a:gd name="connsiteY3" fmla="*/ 44154 h 591777"/>
                <a:gd name="connsiteX4" fmla="*/ 575242 w 658226"/>
                <a:gd name="connsiteY4" fmla="*/ 342685 h 591777"/>
                <a:gd name="connsiteX5" fmla="*/ 590473 w 658226"/>
                <a:gd name="connsiteY5" fmla="*/ 555882 h 591777"/>
                <a:gd name="connsiteX6" fmla="*/ 294884 w 658226"/>
                <a:gd name="connsiteY6" fmla="*/ 562989 h 591777"/>
                <a:gd name="connsiteX7" fmla="*/ 53579 w 658226"/>
                <a:gd name="connsiteY7" fmla="*/ 572661 h 591777"/>
                <a:gd name="connsiteX8" fmla="*/ 48082 w 658226"/>
                <a:gd name="connsiteY8" fmla="*/ 348786 h 591777"/>
                <a:gd name="connsiteX0" fmla="*/ 48082 w 665444"/>
                <a:gd name="connsiteY0" fmla="*/ 348786 h 591777"/>
                <a:gd name="connsiteX1" fmla="*/ 45190 w 665444"/>
                <a:gd name="connsiteY1" fmla="*/ 44154 h 591777"/>
                <a:gd name="connsiteX2" fmla="*/ 294884 w 665444"/>
                <a:gd name="connsiteY2" fmla="*/ 359 h 591777"/>
                <a:gd name="connsiteX3" fmla="*/ 640807 w 665444"/>
                <a:gd name="connsiteY3" fmla="*/ 44154 h 591777"/>
                <a:gd name="connsiteX4" fmla="*/ 617187 w 665444"/>
                <a:gd name="connsiteY4" fmla="*/ 360607 h 591777"/>
                <a:gd name="connsiteX5" fmla="*/ 590473 w 665444"/>
                <a:gd name="connsiteY5" fmla="*/ 555882 h 591777"/>
                <a:gd name="connsiteX6" fmla="*/ 294884 w 665444"/>
                <a:gd name="connsiteY6" fmla="*/ 562989 h 591777"/>
                <a:gd name="connsiteX7" fmla="*/ 53579 w 665444"/>
                <a:gd name="connsiteY7" fmla="*/ 572661 h 591777"/>
                <a:gd name="connsiteX8" fmla="*/ 48082 w 665444"/>
                <a:gd name="connsiteY8" fmla="*/ 348786 h 59177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665444" h="591777">
                  <a:moveTo>
                    <a:pt x="48082" y="348786"/>
                  </a:moveTo>
                  <a:cubicBezTo>
                    <a:pt x="46684" y="260702"/>
                    <a:pt x="-57463" y="91040"/>
                    <a:pt x="45190" y="44154"/>
                  </a:cubicBezTo>
                  <a:cubicBezTo>
                    <a:pt x="147843" y="-2732"/>
                    <a:pt x="195615" y="359"/>
                    <a:pt x="294884" y="359"/>
                  </a:cubicBezTo>
                  <a:cubicBezTo>
                    <a:pt x="394153" y="359"/>
                    <a:pt x="584294" y="-6926"/>
                    <a:pt x="640807" y="44154"/>
                  </a:cubicBezTo>
                  <a:cubicBezTo>
                    <a:pt x="697321" y="95234"/>
                    <a:pt x="642354" y="292097"/>
                    <a:pt x="617187" y="360607"/>
                  </a:cubicBezTo>
                  <a:cubicBezTo>
                    <a:pt x="592020" y="429117"/>
                    <a:pt x="646986" y="513191"/>
                    <a:pt x="590473" y="555882"/>
                  </a:cubicBezTo>
                  <a:cubicBezTo>
                    <a:pt x="533960" y="598573"/>
                    <a:pt x="384366" y="560193"/>
                    <a:pt x="294884" y="562989"/>
                  </a:cubicBezTo>
                  <a:cubicBezTo>
                    <a:pt x="205402" y="565786"/>
                    <a:pt x="156232" y="619547"/>
                    <a:pt x="53579" y="572661"/>
                  </a:cubicBezTo>
                  <a:cubicBezTo>
                    <a:pt x="-49074" y="525775"/>
                    <a:pt x="49480" y="436870"/>
                    <a:pt x="48082" y="348786"/>
                  </a:cubicBezTo>
                  <a:close/>
                </a:path>
              </a:pathLst>
            </a:custGeom>
            <a:noFill/>
            <a:ln w="19050">
              <a:solidFill>
                <a:schemeClr val="accent1">
                  <a:lumMod val="5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x-none" sz="1400" b="1" dirty="0">
                  <a:latin typeface="Calibri" panose="020F0502020204030204" pitchFamily="34" charset="0"/>
                  <a:cs typeface="Arial" panose="020B0604020202020204" pitchFamily="34" charset="0"/>
                </a:rPr>
                <a:t>GCAP</a:t>
              </a:r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  <a:endParaRPr lang="x-none" b="1" dirty="0">
                <a:latin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xmlns="" id="{2CAD3D7A-943A-1AD1-190A-6AA3C49F1C21}"/>
                </a:ext>
              </a:extLst>
            </p:cNvPr>
            <p:cNvSpPr txBox="1"/>
            <p:nvPr/>
          </p:nvSpPr>
          <p:spPr>
            <a:xfrm>
              <a:off x="4358776" y="1458650"/>
              <a:ext cx="778124" cy="476071"/>
            </a:xfrm>
            <a:custGeom>
              <a:avLst/>
              <a:gdLst>
                <a:gd name="connsiteX0" fmla="*/ 0 w 778124"/>
                <a:gd name="connsiteY0" fmla="*/ 238036 h 476071"/>
                <a:gd name="connsiteX1" fmla="*/ 389062 w 778124"/>
                <a:gd name="connsiteY1" fmla="*/ 0 h 476071"/>
                <a:gd name="connsiteX2" fmla="*/ 778124 w 778124"/>
                <a:gd name="connsiteY2" fmla="*/ 238036 h 476071"/>
                <a:gd name="connsiteX3" fmla="*/ 389062 w 778124"/>
                <a:gd name="connsiteY3" fmla="*/ 476072 h 476071"/>
                <a:gd name="connsiteX4" fmla="*/ 0 w 778124"/>
                <a:gd name="connsiteY4" fmla="*/ 238036 h 47607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778124" h="476071" extrusionOk="0">
                  <a:moveTo>
                    <a:pt x="0" y="238036"/>
                  </a:moveTo>
                  <a:cubicBezTo>
                    <a:pt x="-8430" y="90008"/>
                    <a:pt x="180071" y="-38328"/>
                    <a:pt x="389062" y="0"/>
                  </a:cubicBezTo>
                  <a:cubicBezTo>
                    <a:pt x="600527" y="29"/>
                    <a:pt x="782692" y="108970"/>
                    <a:pt x="778124" y="238036"/>
                  </a:cubicBezTo>
                  <a:cubicBezTo>
                    <a:pt x="761184" y="350301"/>
                    <a:pt x="611283" y="469570"/>
                    <a:pt x="389062" y="476072"/>
                  </a:cubicBezTo>
                  <a:cubicBezTo>
                    <a:pt x="176369" y="489233"/>
                    <a:pt x="3407" y="364139"/>
                    <a:pt x="0" y="238036"/>
                  </a:cubicBezTo>
                  <a:close/>
                </a:path>
              </a:pathLst>
            </a:custGeom>
            <a:noFill/>
            <a:ln w="19050">
              <a:solidFill>
                <a:schemeClr val="tx1"/>
              </a:solidFill>
              <a:extLst>
                <a:ext uri="{C807C97D-BFC1-408E-A445-0C87EB9F89A2}">
                  <ask:lineSketchStyleProps xmlns:ask="http://schemas.microsoft.com/office/drawing/2018/sketchyshapes" xmlns="" sd="3130799546">
                    <a:prstGeom prst="ellipse">
                      <a:avLst/>
                    </a:prstGeom>
                    <ask:type>
                      <ask:lineSketchCurved/>
                    </ask:type>
                  </ask:lineSketchStyleProps>
                </a:ext>
              </a:extLst>
            </a:ln>
          </p:spPr>
          <p:txBody>
            <a:bodyPr wrap="none" rtlCol="0">
              <a:spAutoFit/>
            </a:bodyPr>
            <a:lstStyle/>
            <a:p>
              <a:r>
                <a:rPr lang="x-none" sz="1600" b="1" dirty="0">
                  <a:latin typeface="Calibri" panose="020F0502020204030204" pitchFamily="34" charset="0"/>
                  <a:cs typeface="Arial" panose="020B0604020202020204" pitchFamily="34" charset="0"/>
                </a:rPr>
                <a:t>ANP</a:t>
              </a:r>
            </a:p>
          </p:txBody>
        </p:sp>
        <p:sp>
          <p:nvSpPr>
            <p:cNvPr id="87" name="TextBox 200">
              <a:extLst>
                <a:ext uri="{FF2B5EF4-FFF2-40B4-BE49-F238E27FC236}">
                  <a16:creationId xmlns:a16="http://schemas.microsoft.com/office/drawing/2014/main" xmlns="" id="{81EC0CFF-B9F6-3BF3-E8D2-985888484A44}"/>
                </a:ext>
              </a:extLst>
            </p:cNvPr>
            <p:cNvSpPr txBox="1"/>
            <p:nvPr/>
          </p:nvSpPr>
          <p:spPr>
            <a:xfrm>
              <a:off x="5470198" y="1457539"/>
              <a:ext cx="755583" cy="476071"/>
            </a:xfrm>
            <a:custGeom>
              <a:avLst/>
              <a:gdLst>
                <a:gd name="connsiteX0" fmla="*/ 0 w 755583"/>
                <a:gd name="connsiteY0" fmla="*/ 238036 h 476071"/>
                <a:gd name="connsiteX1" fmla="*/ 377792 w 755583"/>
                <a:gd name="connsiteY1" fmla="*/ 0 h 476071"/>
                <a:gd name="connsiteX2" fmla="*/ 755584 w 755583"/>
                <a:gd name="connsiteY2" fmla="*/ 238036 h 476071"/>
                <a:gd name="connsiteX3" fmla="*/ 377792 w 755583"/>
                <a:gd name="connsiteY3" fmla="*/ 476072 h 476071"/>
                <a:gd name="connsiteX4" fmla="*/ 0 w 755583"/>
                <a:gd name="connsiteY4" fmla="*/ 238036 h 47607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755583" h="476071" extrusionOk="0">
                  <a:moveTo>
                    <a:pt x="0" y="238036"/>
                  </a:moveTo>
                  <a:cubicBezTo>
                    <a:pt x="-13632" y="103236"/>
                    <a:pt x="151967" y="1261"/>
                    <a:pt x="377792" y="0"/>
                  </a:cubicBezTo>
                  <a:cubicBezTo>
                    <a:pt x="587861" y="4345"/>
                    <a:pt x="748099" y="100428"/>
                    <a:pt x="755584" y="238036"/>
                  </a:cubicBezTo>
                  <a:cubicBezTo>
                    <a:pt x="783226" y="358376"/>
                    <a:pt x="583898" y="475814"/>
                    <a:pt x="377792" y="476072"/>
                  </a:cubicBezTo>
                  <a:cubicBezTo>
                    <a:pt x="171371" y="476802"/>
                    <a:pt x="834" y="347724"/>
                    <a:pt x="0" y="238036"/>
                  </a:cubicBezTo>
                  <a:close/>
                </a:path>
              </a:pathLst>
            </a:custGeom>
            <a:noFill/>
            <a:ln w="19050">
              <a:solidFill>
                <a:schemeClr val="accent3">
                  <a:lumMod val="75000"/>
                </a:schemeClr>
              </a:solidFill>
              <a:extLst>
                <a:ext uri="{C807C97D-BFC1-408E-A445-0C87EB9F89A2}">
                  <ask:lineSketchStyleProps xmlns:ask="http://schemas.microsoft.com/office/drawing/2018/sketchyshapes" xmlns="" sd="1434197081">
                    <a:prstGeom prst="ellipse">
                      <a:avLst/>
                    </a:prstGeom>
                    <ask:type>
                      <ask:lineSketchCurved/>
                    </ask:type>
                  </ask:lineSketchStyleProps>
                </a:ext>
              </a:extLst>
            </a:ln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x-none" sz="1600" b="1" dirty="0">
                  <a:latin typeface="Calibri" panose="020F0502020204030204" pitchFamily="34" charset="0"/>
                  <a:cs typeface="Arial" panose="020B0604020202020204" pitchFamily="34" charset="0"/>
                </a:rPr>
                <a:t>CNP</a:t>
              </a:r>
              <a:endParaRPr lang="x-none" sz="2000" b="1" dirty="0">
                <a:latin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xmlns="" id="{52D816F0-21FE-B042-B66B-AFE7CF84FE82}"/>
                </a:ext>
              </a:extLst>
            </p:cNvPr>
            <p:cNvSpPr txBox="1"/>
            <p:nvPr/>
          </p:nvSpPr>
          <p:spPr>
            <a:xfrm>
              <a:off x="3007896" y="2013419"/>
              <a:ext cx="120175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b="1" i="1" dirty="0" err="1" smtClean="0">
                  <a:latin typeface="Calibri" panose="020F0502020204030204" pitchFamily="34" charset="0"/>
                  <a:cs typeface="Arial" panose="020B0604020202020204" pitchFamily="34" charset="0"/>
                </a:rPr>
                <a:t>Extracellular</a:t>
              </a:r>
              <a:endParaRPr lang="de-DE" sz="1200" b="1" i="1" dirty="0" smtClean="0">
                <a:latin typeface="Calibri" panose="020F050202020403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de-DE" sz="1200" b="1" i="1" dirty="0" err="1">
                  <a:latin typeface="Calibri" panose="020F0502020204030204" pitchFamily="34" charset="0"/>
                  <a:cs typeface="Arial" panose="020B0604020202020204" pitchFamily="34" charset="0"/>
                </a:rPr>
                <a:t>d</a:t>
              </a:r>
              <a:r>
                <a:rPr lang="de-DE" sz="1200" b="1" i="1" dirty="0" err="1" smtClean="0">
                  <a:latin typeface="Calibri" panose="020F0502020204030204" pitchFamily="34" charset="0"/>
                  <a:cs typeface="Arial" panose="020B0604020202020204" pitchFamily="34" charset="0"/>
                </a:rPr>
                <a:t>omain</a:t>
              </a:r>
              <a:endParaRPr lang="x-none" sz="1600" b="1" i="1" dirty="0">
                <a:latin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TextBox 198">
              <a:extLst>
                <a:ext uri="{FF2B5EF4-FFF2-40B4-BE49-F238E27FC236}">
                  <a16:creationId xmlns:a16="http://schemas.microsoft.com/office/drawing/2014/main" xmlns="" id="{D1284DF5-21AC-7353-17F7-AE6389C7B5B7}"/>
                </a:ext>
              </a:extLst>
            </p:cNvPr>
            <p:cNvSpPr txBox="1"/>
            <p:nvPr/>
          </p:nvSpPr>
          <p:spPr>
            <a:xfrm>
              <a:off x="3602815" y="1504102"/>
              <a:ext cx="6158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x-none" sz="1200" b="1" i="1" dirty="0">
                  <a:latin typeface="Calibri" panose="020F0502020204030204" pitchFamily="34" charset="0"/>
                  <a:cs typeface="Arial" panose="020B0604020202020204" pitchFamily="34" charset="0"/>
                </a:rPr>
                <a:t>Ligand</a:t>
              </a:r>
              <a:endParaRPr lang="x-none" sz="1600" b="1" i="1" dirty="0">
                <a:latin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TextBox 198">
              <a:extLst>
                <a:ext uri="{FF2B5EF4-FFF2-40B4-BE49-F238E27FC236}">
                  <a16:creationId xmlns:a16="http://schemas.microsoft.com/office/drawing/2014/main" xmlns="" id="{F5E0F189-ABC3-2B0B-1F3A-2B2F2FDC0AE3}"/>
                </a:ext>
              </a:extLst>
            </p:cNvPr>
            <p:cNvSpPr txBox="1"/>
            <p:nvPr/>
          </p:nvSpPr>
          <p:spPr>
            <a:xfrm>
              <a:off x="3364416" y="3772222"/>
              <a:ext cx="100790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x-none" sz="1200" b="1" i="1" dirty="0" smtClean="0">
                  <a:latin typeface="Calibri" panose="020F0502020204030204" pitchFamily="34" charset="0"/>
                  <a:cs typeface="Arial" panose="020B0604020202020204" pitchFamily="34" charset="0"/>
                </a:rPr>
                <a:t>Dimerization</a:t>
              </a:r>
              <a:endParaRPr lang="de-DE" sz="1200" b="1" i="1" dirty="0" smtClean="0">
                <a:latin typeface="Calibri" panose="020F050202020403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de-DE" sz="1200" b="1" i="1" dirty="0" err="1" smtClean="0">
                  <a:latin typeface="Calibri" panose="020F0502020204030204" pitchFamily="34" charset="0"/>
                  <a:cs typeface="Arial" panose="020B0604020202020204" pitchFamily="34" charset="0"/>
                </a:rPr>
                <a:t>domain</a:t>
              </a:r>
              <a:endParaRPr lang="x-none" sz="1200" b="1" i="1" dirty="0">
                <a:latin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TextBox 198">
              <a:extLst>
                <a:ext uri="{FF2B5EF4-FFF2-40B4-BE49-F238E27FC236}">
                  <a16:creationId xmlns:a16="http://schemas.microsoft.com/office/drawing/2014/main" xmlns="" id="{4BA508C4-3598-ED30-D0FD-561AD947A251}"/>
                </a:ext>
              </a:extLst>
            </p:cNvPr>
            <p:cNvSpPr txBox="1"/>
            <p:nvPr/>
          </p:nvSpPr>
          <p:spPr>
            <a:xfrm>
              <a:off x="3449055" y="3210879"/>
              <a:ext cx="86818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x-none" sz="1200" b="1" i="1" dirty="0">
                  <a:latin typeface="Calibri" panose="020F0502020204030204" pitchFamily="34" charset="0"/>
                  <a:cs typeface="Arial" panose="020B0604020202020204" pitchFamily="34" charset="0"/>
                </a:rPr>
                <a:t>Kinase like</a:t>
              </a:r>
              <a:r>
                <a:rPr lang="en-US" sz="1200" b="1" i="1" dirty="0">
                  <a:latin typeface="Calibri" panose="020F0502020204030204" pitchFamily="34" charset="0"/>
                  <a:cs typeface="Arial" panose="020B0604020202020204" pitchFamily="34" charset="0"/>
                </a:rPr>
                <a:t> domain</a:t>
              </a:r>
              <a:endParaRPr lang="x-none" sz="1200" b="1" i="1" dirty="0">
                <a:latin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TextBox 198">
              <a:extLst>
                <a:ext uri="{FF2B5EF4-FFF2-40B4-BE49-F238E27FC236}">
                  <a16:creationId xmlns:a16="http://schemas.microsoft.com/office/drawing/2014/main" xmlns="" id="{DD508110-7353-EAF3-A3A8-FBFAD8A94013}"/>
                </a:ext>
              </a:extLst>
            </p:cNvPr>
            <p:cNvSpPr txBox="1"/>
            <p:nvPr/>
          </p:nvSpPr>
          <p:spPr>
            <a:xfrm>
              <a:off x="3106996" y="4295678"/>
              <a:ext cx="144629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200" b="1" i="1" dirty="0">
                  <a:cs typeface="Arial" panose="020B0604020202020204" pitchFamily="34" charset="0"/>
                </a:rPr>
                <a:t>C</a:t>
              </a:r>
              <a:r>
                <a:rPr lang="en-US" sz="1200" b="1" i="1" dirty="0" smtClean="0">
                  <a:cs typeface="Arial" panose="020B0604020202020204" pitchFamily="34" charset="0"/>
                </a:rPr>
                <a:t>yclase </a:t>
              </a:r>
              <a:r>
                <a:rPr lang="en-US" sz="1200" b="1" i="1" dirty="0">
                  <a:cs typeface="Arial" panose="020B0604020202020204" pitchFamily="34" charset="0"/>
                </a:rPr>
                <a:t>catalytic domain</a:t>
              </a:r>
              <a:endParaRPr lang="x-none" sz="1200" b="1" i="1" dirty="0">
                <a:cs typeface="Arial" panose="020B0604020202020204" pitchFamily="34" charset="0"/>
              </a:endParaRPr>
            </a:p>
          </p:txBody>
        </p:sp>
        <p:sp>
          <p:nvSpPr>
            <p:cNvPr id="95" name="Rounded Rectangle 212">
              <a:extLst>
                <a:ext uri="{FF2B5EF4-FFF2-40B4-BE49-F238E27FC236}">
                  <a16:creationId xmlns:a16="http://schemas.microsoft.com/office/drawing/2014/main" xmlns="" id="{9BFB3E14-A2CD-F29D-5B7E-E0AA7E9054A5}"/>
                </a:ext>
              </a:extLst>
            </p:cNvPr>
            <p:cNvSpPr/>
            <p:nvPr/>
          </p:nvSpPr>
          <p:spPr>
            <a:xfrm>
              <a:off x="4490953" y="4820313"/>
              <a:ext cx="612668" cy="338554"/>
            </a:xfrm>
            <a:custGeom>
              <a:avLst/>
              <a:gdLst>
                <a:gd name="connsiteX0" fmla="*/ 0 w 582074"/>
                <a:gd name="connsiteY0" fmla="*/ 62430 h 374571"/>
                <a:gd name="connsiteX1" fmla="*/ 62430 w 582074"/>
                <a:gd name="connsiteY1" fmla="*/ 0 h 374571"/>
                <a:gd name="connsiteX2" fmla="*/ 519644 w 582074"/>
                <a:gd name="connsiteY2" fmla="*/ 0 h 374571"/>
                <a:gd name="connsiteX3" fmla="*/ 582074 w 582074"/>
                <a:gd name="connsiteY3" fmla="*/ 62430 h 374571"/>
                <a:gd name="connsiteX4" fmla="*/ 582074 w 582074"/>
                <a:gd name="connsiteY4" fmla="*/ 312141 h 374571"/>
                <a:gd name="connsiteX5" fmla="*/ 519644 w 582074"/>
                <a:gd name="connsiteY5" fmla="*/ 374571 h 374571"/>
                <a:gd name="connsiteX6" fmla="*/ 62430 w 582074"/>
                <a:gd name="connsiteY6" fmla="*/ 374571 h 374571"/>
                <a:gd name="connsiteX7" fmla="*/ 0 w 582074"/>
                <a:gd name="connsiteY7" fmla="*/ 312141 h 374571"/>
                <a:gd name="connsiteX8" fmla="*/ 0 w 582074"/>
                <a:gd name="connsiteY8" fmla="*/ 62430 h 37457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582074" h="374571" fill="none" extrusionOk="0">
                  <a:moveTo>
                    <a:pt x="0" y="62430"/>
                  </a:moveTo>
                  <a:cubicBezTo>
                    <a:pt x="-2401" y="30792"/>
                    <a:pt x="29955" y="35"/>
                    <a:pt x="62430" y="0"/>
                  </a:cubicBezTo>
                  <a:cubicBezTo>
                    <a:pt x="112618" y="3386"/>
                    <a:pt x="441438" y="-29531"/>
                    <a:pt x="519644" y="0"/>
                  </a:cubicBezTo>
                  <a:cubicBezTo>
                    <a:pt x="558093" y="200"/>
                    <a:pt x="581513" y="31517"/>
                    <a:pt x="582074" y="62430"/>
                  </a:cubicBezTo>
                  <a:cubicBezTo>
                    <a:pt x="579653" y="109850"/>
                    <a:pt x="567647" y="261998"/>
                    <a:pt x="582074" y="312141"/>
                  </a:cubicBezTo>
                  <a:cubicBezTo>
                    <a:pt x="582494" y="346378"/>
                    <a:pt x="554315" y="375506"/>
                    <a:pt x="519644" y="374571"/>
                  </a:cubicBezTo>
                  <a:cubicBezTo>
                    <a:pt x="408756" y="404825"/>
                    <a:pt x="240589" y="338776"/>
                    <a:pt x="62430" y="374571"/>
                  </a:cubicBezTo>
                  <a:cubicBezTo>
                    <a:pt x="33574" y="375144"/>
                    <a:pt x="919" y="347283"/>
                    <a:pt x="0" y="312141"/>
                  </a:cubicBezTo>
                  <a:cubicBezTo>
                    <a:pt x="-21171" y="214168"/>
                    <a:pt x="20822" y="158129"/>
                    <a:pt x="0" y="62430"/>
                  </a:cubicBezTo>
                  <a:close/>
                </a:path>
                <a:path w="582074" h="374571" stroke="0" extrusionOk="0">
                  <a:moveTo>
                    <a:pt x="0" y="62430"/>
                  </a:moveTo>
                  <a:cubicBezTo>
                    <a:pt x="2449" y="31833"/>
                    <a:pt x="26796" y="5167"/>
                    <a:pt x="62430" y="0"/>
                  </a:cubicBezTo>
                  <a:cubicBezTo>
                    <a:pt x="269678" y="33823"/>
                    <a:pt x="355211" y="36715"/>
                    <a:pt x="519644" y="0"/>
                  </a:cubicBezTo>
                  <a:cubicBezTo>
                    <a:pt x="555599" y="-5378"/>
                    <a:pt x="582809" y="26088"/>
                    <a:pt x="582074" y="62430"/>
                  </a:cubicBezTo>
                  <a:cubicBezTo>
                    <a:pt x="593199" y="91376"/>
                    <a:pt x="574101" y="197707"/>
                    <a:pt x="582074" y="312141"/>
                  </a:cubicBezTo>
                  <a:cubicBezTo>
                    <a:pt x="585374" y="344478"/>
                    <a:pt x="550395" y="374997"/>
                    <a:pt x="519644" y="374571"/>
                  </a:cubicBezTo>
                  <a:cubicBezTo>
                    <a:pt x="442361" y="382786"/>
                    <a:pt x="157377" y="403208"/>
                    <a:pt x="62430" y="374571"/>
                  </a:cubicBezTo>
                  <a:cubicBezTo>
                    <a:pt x="23658" y="375497"/>
                    <a:pt x="6810" y="347146"/>
                    <a:pt x="0" y="312141"/>
                  </a:cubicBezTo>
                  <a:cubicBezTo>
                    <a:pt x="-18088" y="212033"/>
                    <a:pt x="20045" y="126444"/>
                    <a:pt x="0" y="62430"/>
                  </a:cubicBezTo>
                  <a:close/>
                </a:path>
              </a:pathLst>
            </a:custGeom>
            <a:solidFill>
              <a:schemeClr val="bg1"/>
            </a:solidFill>
            <a:ln w="19050">
              <a:solidFill>
                <a:schemeClr val="tx1"/>
              </a:solidFill>
              <a:extLst>
                <a:ext uri="{C807C97D-BFC1-408E-A445-0C87EB9F89A2}">
                  <ask:lineSketchStyleProps xmlns:ask="http://schemas.microsoft.com/office/drawing/2018/sketchyshapes" xmlns="" sd="2024408008">
                    <a:prstGeom prst="roundRect">
                      <a:avLst/>
                    </a:prstGeom>
                    <ask:type>
                      <ask:lineSketchCurved/>
                    </ask:type>
                  </ask:lineSketchStyleProps>
                </a:ext>
              </a:extLst>
            </a:ln>
          </p:spPr>
          <p:txBody>
            <a:bodyPr wrap="none">
              <a:spAutoFit/>
            </a:bodyPr>
            <a:lstStyle/>
            <a:p>
              <a:r>
                <a:rPr lang="x-none" sz="1600" b="1" dirty="0" smtClean="0">
                  <a:latin typeface="Calibri" panose="020F0502020204030204" pitchFamily="34" charset="0"/>
                  <a:cs typeface="Arial" panose="020B0604020202020204" pitchFamily="34" charset="0"/>
                </a:rPr>
                <a:t>GC</a:t>
              </a:r>
              <a:r>
                <a:rPr lang="de-DE" sz="1600" b="1" dirty="0" smtClean="0">
                  <a:latin typeface="Calibri" panose="020F0502020204030204" pitchFamily="34" charset="0"/>
                  <a:cs typeface="Arial" panose="020B0604020202020204" pitchFamily="34" charset="0"/>
                </a:rPr>
                <a:t>-</a:t>
              </a:r>
              <a:r>
                <a:rPr lang="x-none" sz="1600" b="1" dirty="0" smtClean="0">
                  <a:latin typeface="Calibri" panose="020F0502020204030204" pitchFamily="34" charset="0"/>
                  <a:cs typeface="Arial" panose="020B0604020202020204" pitchFamily="34" charset="0"/>
                </a:rPr>
                <a:t>A</a:t>
              </a:r>
              <a:endParaRPr lang="x-none" sz="1200" dirty="0">
                <a:cs typeface="Arial" panose="020B0604020202020204" pitchFamily="34" charset="0"/>
              </a:endParaRPr>
            </a:p>
          </p:txBody>
        </p:sp>
        <p:sp>
          <p:nvSpPr>
            <p:cNvPr id="96" name="Rounded Rectangle 213">
              <a:extLst>
                <a:ext uri="{FF2B5EF4-FFF2-40B4-BE49-F238E27FC236}">
                  <a16:creationId xmlns:a16="http://schemas.microsoft.com/office/drawing/2014/main" xmlns="" id="{534B0B75-7AC0-AD30-CD8C-C47A4192833C}"/>
                </a:ext>
              </a:extLst>
            </p:cNvPr>
            <p:cNvSpPr/>
            <p:nvPr/>
          </p:nvSpPr>
          <p:spPr>
            <a:xfrm>
              <a:off x="5672953" y="4826586"/>
              <a:ext cx="603050" cy="338554"/>
            </a:xfrm>
            <a:custGeom>
              <a:avLst/>
              <a:gdLst>
                <a:gd name="connsiteX0" fmla="*/ 0 w 571898"/>
                <a:gd name="connsiteY0" fmla="*/ 62430 h 374571"/>
                <a:gd name="connsiteX1" fmla="*/ 62430 w 571898"/>
                <a:gd name="connsiteY1" fmla="*/ 0 h 374571"/>
                <a:gd name="connsiteX2" fmla="*/ 509468 w 571898"/>
                <a:gd name="connsiteY2" fmla="*/ 0 h 374571"/>
                <a:gd name="connsiteX3" fmla="*/ 571898 w 571898"/>
                <a:gd name="connsiteY3" fmla="*/ 62430 h 374571"/>
                <a:gd name="connsiteX4" fmla="*/ 571898 w 571898"/>
                <a:gd name="connsiteY4" fmla="*/ 312141 h 374571"/>
                <a:gd name="connsiteX5" fmla="*/ 509468 w 571898"/>
                <a:gd name="connsiteY5" fmla="*/ 374571 h 374571"/>
                <a:gd name="connsiteX6" fmla="*/ 62430 w 571898"/>
                <a:gd name="connsiteY6" fmla="*/ 374571 h 374571"/>
                <a:gd name="connsiteX7" fmla="*/ 0 w 571898"/>
                <a:gd name="connsiteY7" fmla="*/ 312141 h 374571"/>
                <a:gd name="connsiteX8" fmla="*/ 0 w 571898"/>
                <a:gd name="connsiteY8" fmla="*/ 62430 h 37457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571898" h="374571" fill="none" extrusionOk="0">
                  <a:moveTo>
                    <a:pt x="0" y="62430"/>
                  </a:moveTo>
                  <a:cubicBezTo>
                    <a:pt x="-2738" y="30774"/>
                    <a:pt x="23814" y="-196"/>
                    <a:pt x="62430" y="0"/>
                  </a:cubicBezTo>
                  <a:cubicBezTo>
                    <a:pt x="135664" y="25021"/>
                    <a:pt x="329739" y="15885"/>
                    <a:pt x="509468" y="0"/>
                  </a:cubicBezTo>
                  <a:cubicBezTo>
                    <a:pt x="542530" y="-6354"/>
                    <a:pt x="575407" y="24701"/>
                    <a:pt x="571898" y="62430"/>
                  </a:cubicBezTo>
                  <a:cubicBezTo>
                    <a:pt x="584093" y="137810"/>
                    <a:pt x="583072" y="227655"/>
                    <a:pt x="571898" y="312141"/>
                  </a:cubicBezTo>
                  <a:cubicBezTo>
                    <a:pt x="571005" y="344058"/>
                    <a:pt x="545871" y="373088"/>
                    <a:pt x="509468" y="374571"/>
                  </a:cubicBezTo>
                  <a:cubicBezTo>
                    <a:pt x="399964" y="364820"/>
                    <a:pt x="208316" y="350389"/>
                    <a:pt x="62430" y="374571"/>
                  </a:cubicBezTo>
                  <a:cubicBezTo>
                    <a:pt x="23767" y="375794"/>
                    <a:pt x="-127" y="347287"/>
                    <a:pt x="0" y="312141"/>
                  </a:cubicBezTo>
                  <a:cubicBezTo>
                    <a:pt x="-9465" y="214706"/>
                    <a:pt x="-20296" y="158012"/>
                    <a:pt x="0" y="62430"/>
                  </a:cubicBezTo>
                  <a:close/>
                </a:path>
                <a:path w="571898" h="374571" stroke="0" extrusionOk="0">
                  <a:moveTo>
                    <a:pt x="0" y="62430"/>
                  </a:moveTo>
                  <a:cubicBezTo>
                    <a:pt x="2719" y="23484"/>
                    <a:pt x="32049" y="2908"/>
                    <a:pt x="62430" y="0"/>
                  </a:cubicBezTo>
                  <a:cubicBezTo>
                    <a:pt x="204547" y="-19289"/>
                    <a:pt x="323394" y="20084"/>
                    <a:pt x="509468" y="0"/>
                  </a:cubicBezTo>
                  <a:cubicBezTo>
                    <a:pt x="541245" y="-635"/>
                    <a:pt x="577126" y="23737"/>
                    <a:pt x="571898" y="62430"/>
                  </a:cubicBezTo>
                  <a:cubicBezTo>
                    <a:pt x="591355" y="154885"/>
                    <a:pt x="576556" y="187443"/>
                    <a:pt x="571898" y="312141"/>
                  </a:cubicBezTo>
                  <a:cubicBezTo>
                    <a:pt x="572434" y="351937"/>
                    <a:pt x="547282" y="370144"/>
                    <a:pt x="509468" y="374571"/>
                  </a:cubicBezTo>
                  <a:cubicBezTo>
                    <a:pt x="399851" y="337721"/>
                    <a:pt x="187136" y="349293"/>
                    <a:pt x="62430" y="374571"/>
                  </a:cubicBezTo>
                  <a:cubicBezTo>
                    <a:pt x="31063" y="370502"/>
                    <a:pt x="-361" y="346245"/>
                    <a:pt x="0" y="312141"/>
                  </a:cubicBezTo>
                  <a:cubicBezTo>
                    <a:pt x="-19636" y="190510"/>
                    <a:pt x="1242" y="164890"/>
                    <a:pt x="0" y="62430"/>
                  </a:cubicBezTo>
                  <a:close/>
                </a:path>
              </a:pathLst>
            </a:custGeom>
            <a:solidFill>
              <a:schemeClr val="bg1"/>
            </a:solidFill>
            <a:ln w="19050">
              <a:solidFill>
                <a:schemeClr val="tx1"/>
              </a:solidFill>
              <a:extLst>
                <a:ext uri="{C807C97D-BFC1-408E-A445-0C87EB9F89A2}">
                  <ask:lineSketchStyleProps xmlns:ask="http://schemas.microsoft.com/office/drawing/2018/sketchyshapes" xmlns="" sd="809130306">
                    <a:prstGeom prst="roundRect">
                      <a:avLst/>
                    </a:prstGeom>
                    <ask:type>
                      <ask:lineSketchCurved/>
                    </ask:type>
                  </ask:lineSketchStyleProps>
                </a:ext>
              </a:extLst>
            </a:ln>
          </p:spPr>
          <p:txBody>
            <a:bodyPr wrap="none">
              <a:spAutoFit/>
            </a:bodyPr>
            <a:lstStyle/>
            <a:p>
              <a:r>
                <a:rPr lang="x-none" sz="1600" b="1" dirty="0" smtClean="0">
                  <a:latin typeface="Calibri" panose="020F0502020204030204" pitchFamily="34" charset="0"/>
                  <a:cs typeface="Arial" panose="020B0604020202020204" pitchFamily="34" charset="0"/>
                </a:rPr>
                <a:t>GC</a:t>
              </a:r>
              <a:r>
                <a:rPr lang="de-DE" sz="1600" b="1" dirty="0" smtClean="0">
                  <a:latin typeface="Calibri" panose="020F0502020204030204" pitchFamily="34" charset="0"/>
                  <a:cs typeface="Arial" panose="020B0604020202020204" pitchFamily="34" charset="0"/>
                </a:rPr>
                <a:t>-</a:t>
              </a:r>
              <a:r>
                <a:rPr lang="x-none" sz="1600" b="1" dirty="0" smtClean="0">
                  <a:latin typeface="Calibri" panose="020F0502020204030204" pitchFamily="34" charset="0"/>
                  <a:cs typeface="Arial" panose="020B0604020202020204" pitchFamily="34" charset="0"/>
                </a:rPr>
                <a:t>B</a:t>
              </a:r>
              <a:endParaRPr lang="x-none" sz="1200" dirty="0">
                <a:cs typeface="Arial" panose="020B0604020202020204" pitchFamily="34" charset="0"/>
              </a:endParaRPr>
            </a:p>
          </p:txBody>
        </p:sp>
        <p:sp>
          <p:nvSpPr>
            <p:cNvPr id="97" name="Rectangle 96">
              <a:extLst>
                <a:ext uri="{FF2B5EF4-FFF2-40B4-BE49-F238E27FC236}">
                  <a16:creationId xmlns:a16="http://schemas.microsoft.com/office/drawing/2014/main" xmlns="" id="{34DD68B1-6D5B-F32F-FBE3-FCDD1B0A8848}"/>
                </a:ext>
              </a:extLst>
            </p:cNvPr>
            <p:cNvSpPr/>
            <p:nvPr/>
          </p:nvSpPr>
          <p:spPr>
            <a:xfrm>
              <a:off x="8090008" y="5484694"/>
              <a:ext cx="627095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x-none" sz="1400" b="1">
                  <a:latin typeface="Calibri" panose="020F0502020204030204" pitchFamily="34" charset="0"/>
                  <a:cs typeface="Arial" panose="020B0604020202020204" pitchFamily="34" charset="0"/>
                </a:rPr>
                <a:t>cGMP</a:t>
              </a:r>
            </a:p>
          </p:txBody>
        </p:sp>
        <p:sp>
          <p:nvSpPr>
            <p:cNvPr id="99" name="Rectangle 98">
              <a:extLst>
                <a:ext uri="{FF2B5EF4-FFF2-40B4-BE49-F238E27FC236}">
                  <a16:creationId xmlns:a16="http://schemas.microsoft.com/office/drawing/2014/main" xmlns="" id="{5CF45932-B539-5964-4689-A67EF778D734}"/>
                </a:ext>
              </a:extLst>
            </p:cNvPr>
            <p:cNvSpPr/>
            <p:nvPr/>
          </p:nvSpPr>
          <p:spPr>
            <a:xfrm>
              <a:off x="4852132" y="5481909"/>
              <a:ext cx="627095" cy="307777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x-none" sz="1400" b="1" dirty="0">
                  <a:latin typeface="Calibri" panose="020F0502020204030204" pitchFamily="34" charset="0"/>
                  <a:cs typeface="Arial" panose="020B0604020202020204" pitchFamily="34" charset="0"/>
                </a:rPr>
                <a:t>cGMP</a:t>
              </a:r>
            </a:p>
          </p:txBody>
        </p:sp>
        <p:sp>
          <p:nvSpPr>
            <p:cNvPr id="100" name="Rectangle 99">
              <a:extLst>
                <a:ext uri="{FF2B5EF4-FFF2-40B4-BE49-F238E27FC236}">
                  <a16:creationId xmlns:a16="http://schemas.microsoft.com/office/drawing/2014/main" xmlns="" id="{62E7992B-6183-DC15-458A-C56E6A1B136E}"/>
                </a:ext>
              </a:extLst>
            </p:cNvPr>
            <p:cNvSpPr/>
            <p:nvPr/>
          </p:nvSpPr>
          <p:spPr>
            <a:xfrm>
              <a:off x="6019359" y="5481909"/>
              <a:ext cx="627095" cy="307777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x-none" sz="1400" b="1" dirty="0">
                  <a:latin typeface="Calibri" panose="020F0502020204030204" pitchFamily="34" charset="0"/>
                  <a:cs typeface="Arial" panose="020B0604020202020204" pitchFamily="34" charset="0"/>
                </a:rPr>
                <a:t>cGMP</a:t>
              </a:r>
            </a:p>
          </p:txBody>
        </p:sp>
        <p:sp>
          <p:nvSpPr>
            <p:cNvPr id="46" name="Pie 138">
              <a:extLst>
                <a:ext uri="{FF2B5EF4-FFF2-40B4-BE49-F238E27FC236}">
                  <a16:creationId xmlns:a16="http://schemas.microsoft.com/office/drawing/2014/main" xmlns="" id="{89C97D94-8F78-2B8A-C220-1CDF3479FA72}"/>
                </a:ext>
              </a:extLst>
            </p:cNvPr>
            <p:cNvSpPr/>
            <p:nvPr/>
          </p:nvSpPr>
          <p:spPr>
            <a:xfrm rot="20711771">
              <a:off x="4302480" y="1719952"/>
              <a:ext cx="416052" cy="850819"/>
            </a:xfrm>
            <a:prstGeom prst="pie">
              <a:avLst/>
            </a:prstGeom>
            <a:solidFill>
              <a:schemeClr val="accent1">
                <a:lumMod val="75000"/>
              </a:schemeClr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  <a:softEdge rad="12700"/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x-none" sz="1600">
                <a:cs typeface="Arial" panose="020B0604020202020204" pitchFamily="34" charset="0"/>
              </a:endParaRPr>
            </a:p>
          </p:txBody>
        </p:sp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xmlns="" id="{6976F27C-F889-5F94-2584-A3F1146800E3}"/>
                </a:ext>
              </a:extLst>
            </p:cNvPr>
            <p:cNvSpPr txBox="1"/>
            <p:nvPr/>
          </p:nvSpPr>
          <p:spPr>
            <a:xfrm>
              <a:off x="6771399" y="5339089"/>
              <a:ext cx="534121" cy="338554"/>
            </a:xfrm>
            <a:custGeom>
              <a:avLst/>
              <a:gdLst>
                <a:gd name="connsiteX0" fmla="*/ 0 w 534121"/>
                <a:gd name="connsiteY0" fmla="*/ 0 h 338554"/>
                <a:gd name="connsiteX1" fmla="*/ 534121 w 534121"/>
                <a:gd name="connsiteY1" fmla="*/ 0 h 338554"/>
                <a:gd name="connsiteX2" fmla="*/ 534121 w 534121"/>
                <a:gd name="connsiteY2" fmla="*/ 338554 h 338554"/>
                <a:gd name="connsiteX3" fmla="*/ 0 w 534121"/>
                <a:gd name="connsiteY3" fmla="*/ 338554 h 338554"/>
                <a:gd name="connsiteX4" fmla="*/ 0 w 534121"/>
                <a:gd name="connsiteY4" fmla="*/ 0 h 33855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534121" h="338554" extrusionOk="0">
                  <a:moveTo>
                    <a:pt x="0" y="0"/>
                  </a:moveTo>
                  <a:cubicBezTo>
                    <a:pt x="121745" y="-7364"/>
                    <a:pt x="421597" y="20409"/>
                    <a:pt x="534121" y="0"/>
                  </a:cubicBezTo>
                  <a:cubicBezTo>
                    <a:pt x="541891" y="75712"/>
                    <a:pt x="539903" y="192607"/>
                    <a:pt x="534121" y="338554"/>
                  </a:cubicBezTo>
                  <a:cubicBezTo>
                    <a:pt x="333861" y="339130"/>
                    <a:pt x="150323" y="318388"/>
                    <a:pt x="0" y="338554"/>
                  </a:cubicBezTo>
                  <a:cubicBezTo>
                    <a:pt x="16133" y="170659"/>
                    <a:pt x="314" y="141770"/>
                    <a:pt x="0" y="0"/>
                  </a:cubicBezTo>
                  <a:close/>
                </a:path>
              </a:pathLst>
            </a:custGeom>
            <a:noFill/>
            <a:ln w="19050">
              <a:solidFill>
                <a:schemeClr val="tx1"/>
              </a:solidFill>
              <a:extLst>
                <a:ext uri="{C807C97D-BFC1-408E-A445-0C87EB9F89A2}">
                  <ask:lineSketchStyleProps xmlns:ask="http://schemas.microsoft.com/office/drawing/2018/sketchyshapes" xmlns="" sd="3191991822">
                    <a:prstGeom prst="rect">
                      <a:avLst/>
                    </a:prstGeom>
                    <ask:type>
                      <ask:lineSketchFreehand/>
                    </ask:type>
                  </ask:lineSketchStyleProps>
                </a:ext>
              </a:extLst>
            </a:ln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Calibri" panose="020F0502020204030204" pitchFamily="34" charset="0"/>
                  <a:cs typeface="Arial" panose="020B0604020202020204" pitchFamily="34" charset="0"/>
                </a:rPr>
                <a:t>RD3</a:t>
              </a:r>
              <a:endParaRPr lang="x-none" sz="1400" b="1" dirty="0">
                <a:latin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xmlns="" id="{2D4EFF04-8621-115D-E836-84DE8F3EF83C}"/>
                </a:ext>
              </a:extLst>
            </p:cNvPr>
            <p:cNvSpPr/>
            <p:nvPr/>
          </p:nvSpPr>
          <p:spPr>
            <a:xfrm>
              <a:off x="7391385" y="5484694"/>
              <a:ext cx="481927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400" b="1" dirty="0">
                  <a:latin typeface="Calibri" panose="020F0502020204030204" pitchFamily="34" charset="0"/>
                  <a:cs typeface="Arial" panose="020B0604020202020204" pitchFamily="34" charset="0"/>
                </a:rPr>
                <a:t>GTP</a:t>
              </a:r>
              <a:endParaRPr lang="x-none" sz="1400" b="1" dirty="0">
                <a:latin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xmlns="" id="{B18C317F-F2C1-ED4D-9A1B-5391478ECB1E}"/>
                </a:ext>
              </a:extLst>
            </p:cNvPr>
            <p:cNvSpPr/>
            <p:nvPr/>
          </p:nvSpPr>
          <p:spPr>
            <a:xfrm>
              <a:off x="4137840" y="5481909"/>
              <a:ext cx="481927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400" b="1" dirty="0">
                  <a:latin typeface="Calibri" panose="020F0502020204030204" pitchFamily="34" charset="0"/>
                  <a:cs typeface="Arial" panose="020B0604020202020204" pitchFamily="34" charset="0"/>
                </a:rPr>
                <a:t>GTP</a:t>
              </a:r>
              <a:endParaRPr lang="x-none" sz="1400" b="1" dirty="0">
                <a:latin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xmlns="" id="{9376469B-CC21-1170-CD23-0DAFDD6099E7}"/>
                </a:ext>
              </a:extLst>
            </p:cNvPr>
            <p:cNvSpPr/>
            <p:nvPr/>
          </p:nvSpPr>
          <p:spPr>
            <a:xfrm>
              <a:off x="5333858" y="5481909"/>
              <a:ext cx="481927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400" b="1" dirty="0">
                  <a:latin typeface="Calibri" panose="020F0502020204030204" pitchFamily="34" charset="0"/>
                  <a:cs typeface="Arial" panose="020B0604020202020204" pitchFamily="34" charset="0"/>
                </a:rPr>
                <a:t>GTP</a:t>
              </a:r>
              <a:endParaRPr lang="x-none" sz="1400" b="1" dirty="0">
                <a:latin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Arc 83">
              <a:extLst>
                <a:ext uri="{FF2B5EF4-FFF2-40B4-BE49-F238E27FC236}">
                  <a16:creationId xmlns:a16="http://schemas.microsoft.com/office/drawing/2014/main" xmlns="" id="{08266EC1-8A54-4304-AB23-CF9A23ABB665}"/>
                </a:ext>
              </a:extLst>
            </p:cNvPr>
            <p:cNvSpPr/>
            <p:nvPr/>
          </p:nvSpPr>
          <p:spPr>
            <a:xfrm rot="16200000">
              <a:off x="5636406" y="5192008"/>
              <a:ext cx="700075" cy="700075"/>
            </a:xfrm>
            <a:prstGeom prst="arc">
              <a:avLst>
                <a:gd name="adj1" fmla="val 16871440"/>
                <a:gd name="adj2" fmla="val 5232522"/>
              </a:avLst>
            </a:prstGeom>
            <a:ln w="19050">
              <a:solidFill>
                <a:schemeClr val="tx1"/>
              </a:solidFill>
              <a:headEnd type="none" w="med" len="med"/>
              <a:tailEnd type="triangl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x-none" sz="1600">
                <a:cs typeface="Arial" panose="020B0604020202020204" pitchFamily="34" charset="0"/>
              </a:endParaRPr>
            </a:p>
          </p:txBody>
        </p:sp>
        <p:sp>
          <p:nvSpPr>
            <p:cNvPr id="101" name="Arc 100">
              <a:extLst>
                <a:ext uri="{FF2B5EF4-FFF2-40B4-BE49-F238E27FC236}">
                  <a16:creationId xmlns:a16="http://schemas.microsoft.com/office/drawing/2014/main" xmlns="" id="{98C96D0A-5682-D836-0F82-A8FAB94332CC}"/>
                </a:ext>
              </a:extLst>
            </p:cNvPr>
            <p:cNvSpPr/>
            <p:nvPr/>
          </p:nvSpPr>
          <p:spPr>
            <a:xfrm rot="16200000">
              <a:off x="7700684" y="5178330"/>
              <a:ext cx="700075" cy="700075"/>
            </a:xfrm>
            <a:prstGeom prst="arc">
              <a:avLst>
                <a:gd name="adj1" fmla="val 16871440"/>
                <a:gd name="adj2" fmla="val 5232522"/>
              </a:avLst>
            </a:prstGeom>
            <a:ln w="19050">
              <a:solidFill>
                <a:schemeClr val="tx1"/>
              </a:solidFill>
              <a:headEnd type="none" w="med" len="med"/>
              <a:tailEnd type="triangl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x-none" sz="1600">
                <a:cs typeface="Arial" panose="020B0604020202020204" pitchFamily="34" charset="0"/>
              </a:endParaRPr>
            </a:p>
          </p:txBody>
        </p:sp>
        <p:sp>
          <p:nvSpPr>
            <p:cNvPr id="21" name="Oval 20">
              <a:extLst>
                <a:ext uri="{FF2B5EF4-FFF2-40B4-BE49-F238E27FC236}">
                  <a16:creationId xmlns:a16="http://schemas.microsoft.com/office/drawing/2014/main" xmlns="" id="{8B072F07-7685-F598-9956-B82037DEFFAA}"/>
                </a:ext>
              </a:extLst>
            </p:cNvPr>
            <p:cNvSpPr/>
            <p:nvPr/>
          </p:nvSpPr>
          <p:spPr>
            <a:xfrm>
              <a:off x="8007042" y="4089059"/>
              <a:ext cx="322326" cy="803329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  <a:softEdge rad="12700"/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x-none" sz="1600">
                <a:cs typeface="Arial" panose="020B0604020202020204" pitchFamily="34" charset="0"/>
              </a:endParaRPr>
            </a:p>
          </p:txBody>
        </p:sp>
        <p:sp>
          <p:nvSpPr>
            <p:cNvPr id="93" name="Rounded Rectangle 210">
              <a:extLst>
                <a:ext uri="{FF2B5EF4-FFF2-40B4-BE49-F238E27FC236}">
                  <a16:creationId xmlns:a16="http://schemas.microsoft.com/office/drawing/2014/main" xmlns="" id="{5451D7EA-287F-0C51-B741-DFAA69F81AD7}"/>
                </a:ext>
              </a:extLst>
            </p:cNvPr>
            <p:cNvSpPr/>
            <p:nvPr/>
          </p:nvSpPr>
          <p:spPr>
            <a:xfrm>
              <a:off x="7793308" y="4810359"/>
              <a:ext cx="560010" cy="374571"/>
            </a:xfrm>
            <a:custGeom>
              <a:avLst/>
              <a:gdLst>
                <a:gd name="connsiteX0" fmla="*/ 0 w 560010"/>
                <a:gd name="connsiteY0" fmla="*/ 62430 h 374571"/>
                <a:gd name="connsiteX1" fmla="*/ 62430 w 560010"/>
                <a:gd name="connsiteY1" fmla="*/ 0 h 374571"/>
                <a:gd name="connsiteX2" fmla="*/ 497580 w 560010"/>
                <a:gd name="connsiteY2" fmla="*/ 0 h 374571"/>
                <a:gd name="connsiteX3" fmla="*/ 560010 w 560010"/>
                <a:gd name="connsiteY3" fmla="*/ 62430 h 374571"/>
                <a:gd name="connsiteX4" fmla="*/ 560010 w 560010"/>
                <a:gd name="connsiteY4" fmla="*/ 312141 h 374571"/>
                <a:gd name="connsiteX5" fmla="*/ 497580 w 560010"/>
                <a:gd name="connsiteY5" fmla="*/ 374571 h 374571"/>
                <a:gd name="connsiteX6" fmla="*/ 62430 w 560010"/>
                <a:gd name="connsiteY6" fmla="*/ 374571 h 374571"/>
                <a:gd name="connsiteX7" fmla="*/ 0 w 560010"/>
                <a:gd name="connsiteY7" fmla="*/ 312141 h 374571"/>
                <a:gd name="connsiteX8" fmla="*/ 0 w 560010"/>
                <a:gd name="connsiteY8" fmla="*/ 62430 h 37457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560010" h="374571" fill="none" extrusionOk="0">
                  <a:moveTo>
                    <a:pt x="0" y="62430"/>
                  </a:moveTo>
                  <a:cubicBezTo>
                    <a:pt x="-4340" y="28965"/>
                    <a:pt x="28151" y="-603"/>
                    <a:pt x="62430" y="0"/>
                  </a:cubicBezTo>
                  <a:cubicBezTo>
                    <a:pt x="229436" y="-21393"/>
                    <a:pt x="302097" y="-26417"/>
                    <a:pt x="497580" y="0"/>
                  </a:cubicBezTo>
                  <a:cubicBezTo>
                    <a:pt x="530601" y="-753"/>
                    <a:pt x="557475" y="27436"/>
                    <a:pt x="560010" y="62430"/>
                  </a:cubicBezTo>
                  <a:cubicBezTo>
                    <a:pt x="554551" y="105792"/>
                    <a:pt x="549519" y="272210"/>
                    <a:pt x="560010" y="312141"/>
                  </a:cubicBezTo>
                  <a:cubicBezTo>
                    <a:pt x="559587" y="346318"/>
                    <a:pt x="533131" y="374532"/>
                    <a:pt x="497580" y="374571"/>
                  </a:cubicBezTo>
                  <a:cubicBezTo>
                    <a:pt x="412509" y="383163"/>
                    <a:pt x="148766" y="351941"/>
                    <a:pt x="62430" y="374571"/>
                  </a:cubicBezTo>
                  <a:cubicBezTo>
                    <a:pt x="23546" y="375322"/>
                    <a:pt x="366" y="345219"/>
                    <a:pt x="0" y="312141"/>
                  </a:cubicBezTo>
                  <a:cubicBezTo>
                    <a:pt x="-8736" y="278496"/>
                    <a:pt x="21092" y="112126"/>
                    <a:pt x="0" y="62430"/>
                  </a:cubicBezTo>
                  <a:close/>
                </a:path>
                <a:path w="560010" h="374571" stroke="0" extrusionOk="0">
                  <a:moveTo>
                    <a:pt x="0" y="62430"/>
                  </a:moveTo>
                  <a:cubicBezTo>
                    <a:pt x="3851" y="25278"/>
                    <a:pt x="28783" y="-5522"/>
                    <a:pt x="62430" y="0"/>
                  </a:cubicBezTo>
                  <a:cubicBezTo>
                    <a:pt x="159800" y="30140"/>
                    <a:pt x="421281" y="-38955"/>
                    <a:pt x="497580" y="0"/>
                  </a:cubicBezTo>
                  <a:cubicBezTo>
                    <a:pt x="532309" y="2701"/>
                    <a:pt x="560787" y="27756"/>
                    <a:pt x="560010" y="62430"/>
                  </a:cubicBezTo>
                  <a:cubicBezTo>
                    <a:pt x="579557" y="183530"/>
                    <a:pt x="557416" y="188616"/>
                    <a:pt x="560010" y="312141"/>
                  </a:cubicBezTo>
                  <a:cubicBezTo>
                    <a:pt x="559891" y="344555"/>
                    <a:pt x="532733" y="371751"/>
                    <a:pt x="497580" y="374571"/>
                  </a:cubicBezTo>
                  <a:cubicBezTo>
                    <a:pt x="408484" y="339663"/>
                    <a:pt x="229404" y="381651"/>
                    <a:pt x="62430" y="374571"/>
                  </a:cubicBezTo>
                  <a:cubicBezTo>
                    <a:pt x="28988" y="374100"/>
                    <a:pt x="3439" y="344648"/>
                    <a:pt x="0" y="312141"/>
                  </a:cubicBezTo>
                  <a:cubicBezTo>
                    <a:pt x="-18617" y="249653"/>
                    <a:pt x="-1779" y="127885"/>
                    <a:pt x="0" y="62430"/>
                  </a:cubicBezTo>
                  <a:close/>
                </a:path>
              </a:pathLst>
            </a:custGeom>
            <a:solidFill>
              <a:schemeClr val="bg1"/>
            </a:solidFill>
            <a:ln w="19050">
              <a:solidFill>
                <a:schemeClr val="tx1"/>
              </a:solidFill>
              <a:extLst>
                <a:ext uri="{C807C97D-BFC1-408E-A445-0C87EB9F89A2}">
                  <ask:lineSketchStyleProps xmlns:ask="http://schemas.microsoft.com/office/drawing/2018/sketchyshapes" xmlns="" sd="283701389">
                    <a:prstGeom prst="roundRect">
                      <a:avLst/>
                    </a:prstGeom>
                    <ask:type>
                      <ask:lineSketchCurved/>
                    </ask:type>
                  </ask:lineSketchStyleProps>
                </a:ext>
              </a:extLst>
            </a:ln>
          </p:spPr>
          <p:txBody>
            <a:bodyPr wrap="none">
              <a:spAutoFit/>
            </a:bodyPr>
            <a:lstStyle/>
            <a:p>
              <a:r>
                <a:rPr lang="x-none" sz="1600" b="1" dirty="0">
                  <a:latin typeface="Calibri" panose="020F0502020204030204" pitchFamily="34" charset="0"/>
                  <a:cs typeface="Arial" panose="020B0604020202020204" pitchFamily="34" charset="0"/>
                </a:rPr>
                <a:t>GCE</a:t>
              </a:r>
              <a:endParaRPr lang="x-none" sz="1200" dirty="0">
                <a:cs typeface="Arial" panose="020B0604020202020204" pitchFamily="34" charset="0"/>
              </a:endParaRPr>
            </a:p>
          </p:txBody>
        </p:sp>
        <p:cxnSp>
          <p:nvCxnSpPr>
            <p:cNvPr id="107" name="Straight Connector 106">
              <a:extLst>
                <a:ext uri="{FF2B5EF4-FFF2-40B4-BE49-F238E27FC236}">
                  <a16:creationId xmlns:a16="http://schemas.microsoft.com/office/drawing/2014/main" xmlns="" id="{6995B5EC-FCCC-DC33-BC60-CD63C718D1D7}"/>
                </a:ext>
              </a:extLst>
            </p:cNvPr>
            <p:cNvCxnSpPr>
              <a:cxnSpLocks/>
            </p:cNvCxnSpPr>
            <p:nvPr/>
          </p:nvCxnSpPr>
          <p:spPr>
            <a:xfrm>
              <a:off x="5342489" y="2648082"/>
              <a:ext cx="0" cy="145404"/>
            </a:xfrm>
            <a:prstGeom prst="line">
              <a:avLst/>
            </a:prstGeom>
            <a:ln w="38100">
              <a:solidFill>
                <a:srgbClr val="95C11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" name="Straight Arrow Connector 111">
              <a:extLst>
                <a:ext uri="{FF2B5EF4-FFF2-40B4-BE49-F238E27FC236}">
                  <a16:creationId xmlns:a16="http://schemas.microsoft.com/office/drawing/2014/main" xmlns="" id="{14EBB0D9-0D8B-347A-1BDA-CC3B6D6C0A48}"/>
                </a:ext>
              </a:extLst>
            </p:cNvPr>
            <p:cNvCxnSpPr>
              <a:cxnSpLocks/>
              <a:stCxn id="85" idx="6"/>
            </p:cNvCxnSpPr>
            <p:nvPr/>
          </p:nvCxnSpPr>
          <p:spPr>
            <a:xfrm flipH="1">
              <a:off x="8612567" y="4025769"/>
              <a:ext cx="351108" cy="23927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26" name="Group 125">
              <a:extLst>
                <a:ext uri="{FF2B5EF4-FFF2-40B4-BE49-F238E27FC236}">
                  <a16:creationId xmlns:a16="http://schemas.microsoft.com/office/drawing/2014/main" xmlns="" id="{105A60F6-2B1F-E696-A814-6C13472E7B36}"/>
                </a:ext>
              </a:extLst>
            </p:cNvPr>
            <p:cNvGrpSpPr/>
            <p:nvPr/>
          </p:nvGrpSpPr>
          <p:grpSpPr>
            <a:xfrm rot="19696560">
              <a:off x="6300328" y="5093154"/>
              <a:ext cx="300038" cy="75661"/>
              <a:chOff x="6415102" y="4900477"/>
              <a:chExt cx="300038" cy="75661"/>
            </a:xfrm>
          </p:grpSpPr>
          <p:cxnSp>
            <p:nvCxnSpPr>
              <p:cNvPr id="121" name="Straight Connector 120">
                <a:extLst>
                  <a:ext uri="{FF2B5EF4-FFF2-40B4-BE49-F238E27FC236}">
                    <a16:creationId xmlns:a16="http://schemas.microsoft.com/office/drawing/2014/main" xmlns="" id="{21C3E2C7-9D95-A382-9118-E1D20F9D5A1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415102" y="4941088"/>
                <a:ext cx="30003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2" name="Straight Connector 121">
                <a:extLst>
                  <a:ext uri="{FF2B5EF4-FFF2-40B4-BE49-F238E27FC236}">
                    <a16:creationId xmlns:a16="http://schemas.microsoft.com/office/drawing/2014/main" xmlns="" id="{9B8EE16F-58F8-2E77-A06A-8B81C5D2BD5F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415102" y="4900477"/>
                <a:ext cx="0" cy="75661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7" name="Group 126">
              <a:extLst>
                <a:ext uri="{FF2B5EF4-FFF2-40B4-BE49-F238E27FC236}">
                  <a16:creationId xmlns:a16="http://schemas.microsoft.com/office/drawing/2014/main" xmlns="" id="{92F1EF68-4807-007B-89C7-750BB69641DA}"/>
                </a:ext>
              </a:extLst>
            </p:cNvPr>
            <p:cNvGrpSpPr/>
            <p:nvPr/>
          </p:nvGrpSpPr>
          <p:grpSpPr>
            <a:xfrm rot="12883773">
              <a:off x="7300345" y="5121036"/>
              <a:ext cx="300038" cy="75661"/>
              <a:chOff x="6415102" y="4900477"/>
              <a:chExt cx="300038" cy="75661"/>
            </a:xfrm>
          </p:grpSpPr>
          <p:cxnSp>
            <p:nvCxnSpPr>
              <p:cNvPr id="1280" name="Straight Connector 1279">
                <a:extLst>
                  <a:ext uri="{FF2B5EF4-FFF2-40B4-BE49-F238E27FC236}">
                    <a16:creationId xmlns:a16="http://schemas.microsoft.com/office/drawing/2014/main" xmlns="" id="{5430F3A8-885F-E9D2-871D-CDF1DBE43EB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415102" y="4941088"/>
                <a:ext cx="30003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81" name="Straight Connector 1280">
                <a:extLst>
                  <a:ext uri="{FF2B5EF4-FFF2-40B4-BE49-F238E27FC236}">
                    <a16:creationId xmlns:a16="http://schemas.microsoft.com/office/drawing/2014/main" xmlns="" id="{530C8571-741D-DD64-FD92-51BAC71B50ED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415102" y="4900477"/>
                <a:ext cx="0" cy="75661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94" name="Straight Connector 77">
              <a:extLst>
                <a:ext uri="{FF2B5EF4-FFF2-40B4-BE49-F238E27FC236}">
                  <a16:creationId xmlns:a16="http://schemas.microsoft.com/office/drawing/2014/main" xmlns="" id="{A49D9843-D074-2439-8C71-C1335C6079AE}"/>
                </a:ext>
              </a:extLst>
            </p:cNvPr>
            <p:cNvCxnSpPr>
              <a:cxnSpLocks/>
            </p:cNvCxnSpPr>
            <p:nvPr/>
          </p:nvCxnSpPr>
          <p:spPr>
            <a:xfrm>
              <a:off x="6252696" y="2661028"/>
              <a:ext cx="0" cy="145404"/>
            </a:xfrm>
            <a:prstGeom prst="line">
              <a:avLst/>
            </a:prstGeom>
            <a:ln w="38100">
              <a:solidFill>
                <a:srgbClr val="95C11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Straight Connector 77">
              <a:extLst>
                <a:ext uri="{FF2B5EF4-FFF2-40B4-BE49-F238E27FC236}">
                  <a16:creationId xmlns:a16="http://schemas.microsoft.com/office/drawing/2014/main" xmlns="" id="{A49D9843-D074-2439-8C71-C1335C6079AE}"/>
                </a:ext>
              </a:extLst>
            </p:cNvPr>
            <p:cNvCxnSpPr>
              <a:cxnSpLocks/>
            </p:cNvCxnSpPr>
            <p:nvPr/>
          </p:nvCxnSpPr>
          <p:spPr>
            <a:xfrm>
              <a:off x="6755357" y="2656636"/>
              <a:ext cx="0" cy="145404"/>
            </a:xfrm>
            <a:prstGeom prst="line">
              <a:avLst/>
            </a:prstGeom>
            <a:ln w="38100">
              <a:solidFill>
                <a:srgbClr val="95C11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Straight Connector 77">
              <a:extLst>
                <a:ext uri="{FF2B5EF4-FFF2-40B4-BE49-F238E27FC236}">
                  <a16:creationId xmlns:a16="http://schemas.microsoft.com/office/drawing/2014/main" xmlns="" id="{A49D9843-D074-2439-8C71-C1335C6079AE}"/>
                </a:ext>
              </a:extLst>
            </p:cNvPr>
            <p:cNvCxnSpPr>
              <a:cxnSpLocks/>
            </p:cNvCxnSpPr>
            <p:nvPr/>
          </p:nvCxnSpPr>
          <p:spPr>
            <a:xfrm>
              <a:off x="6951451" y="2662884"/>
              <a:ext cx="0" cy="145404"/>
            </a:xfrm>
            <a:prstGeom prst="line">
              <a:avLst/>
            </a:prstGeom>
            <a:ln w="38100">
              <a:solidFill>
                <a:srgbClr val="95C11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Straight Connector 77">
              <a:extLst>
                <a:ext uri="{FF2B5EF4-FFF2-40B4-BE49-F238E27FC236}">
                  <a16:creationId xmlns:a16="http://schemas.microsoft.com/office/drawing/2014/main" xmlns="" id="{A49D9843-D074-2439-8C71-C1335C6079AE}"/>
                </a:ext>
              </a:extLst>
            </p:cNvPr>
            <p:cNvCxnSpPr>
              <a:cxnSpLocks/>
            </p:cNvCxnSpPr>
            <p:nvPr/>
          </p:nvCxnSpPr>
          <p:spPr>
            <a:xfrm>
              <a:off x="6579414" y="2656636"/>
              <a:ext cx="0" cy="145404"/>
            </a:xfrm>
            <a:prstGeom prst="line">
              <a:avLst/>
            </a:prstGeom>
            <a:ln w="38100">
              <a:solidFill>
                <a:srgbClr val="95C11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4" name="Straight Connector 77">
              <a:extLst>
                <a:ext uri="{FF2B5EF4-FFF2-40B4-BE49-F238E27FC236}">
                  <a16:creationId xmlns:a16="http://schemas.microsoft.com/office/drawing/2014/main" xmlns="" id="{A49D9843-D074-2439-8C71-C1335C6079AE}"/>
                </a:ext>
              </a:extLst>
            </p:cNvPr>
            <p:cNvCxnSpPr>
              <a:cxnSpLocks/>
            </p:cNvCxnSpPr>
            <p:nvPr/>
          </p:nvCxnSpPr>
          <p:spPr>
            <a:xfrm>
              <a:off x="6451809" y="2664124"/>
              <a:ext cx="0" cy="145404"/>
            </a:xfrm>
            <a:prstGeom prst="line">
              <a:avLst/>
            </a:prstGeom>
            <a:ln w="38100">
              <a:solidFill>
                <a:srgbClr val="95C11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" name="Straight Connector 77">
              <a:extLst>
                <a:ext uri="{FF2B5EF4-FFF2-40B4-BE49-F238E27FC236}">
                  <a16:creationId xmlns:a16="http://schemas.microsoft.com/office/drawing/2014/main" xmlns="" id="{A49D9843-D074-2439-8C71-C1335C6079AE}"/>
                </a:ext>
              </a:extLst>
            </p:cNvPr>
            <p:cNvCxnSpPr>
              <a:cxnSpLocks/>
            </p:cNvCxnSpPr>
            <p:nvPr/>
          </p:nvCxnSpPr>
          <p:spPr>
            <a:xfrm>
              <a:off x="7136804" y="2662884"/>
              <a:ext cx="0" cy="145404"/>
            </a:xfrm>
            <a:prstGeom prst="line">
              <a:avLst/>
            </a:prstGeom>
            <a:ln w="38100">
              <a:solidFill>
                <a:srgbClr val="95C11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6" name="Straight Connector 77">
              <a:extLst>
                <a:ext uri="{FF2B5EF4-FFF2-40B4-BE49-F238E27FC236}">
                  <a16:creationId xmlns:a16="http://schemas.microsoft.com/office/drawing/2014/main" xmlns="" id="{A49D9843-D074-2439-8C71-C1335C6079AE}"/>
                </a:ext>
              </a:extLst>
            </p:cNvPr>
            <p:cNvCxnSpPr>
              <a:cxnSpLocks/>
            </p:cNvCxnSpPr>
            <p:nvPr/>
          </p:nvCxnSpPr>
          <p:spPr>
            <a:xfrm>
              <a:off x="7280314" y="2671312"/>
              <a:ext cx="0" cy="145404"/>
            </a:xfrm>
            <a:prstGeom prst="line">
              <a:avLst/>
            </a:prstGeom>
            <a:ln w="38100">
              <a:solidFill>
                <a:srgbClr val="95C11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8" name="Straight Connector 77">
              <a:extLst>
                <a:ext uri="{FF2B5EF4-FFF2-40B4-BE49-F238E27FC236}">
                  <a16:creationId xmlns:a16="http://schemas.microsoft.com/office/drawing/2014/main" xmlns="" id="{A49D9843-D074-2439-8C71-C1335C6079AE}"/>
                </a:ext>
              </a:extLst>
            </p:cNvPr>
            <p:cNvCxnSpPr>
              <a:cxnSpLocks/>
            </p:cNvCxnSpPr>
            <p:nvPr/>
          </p:nvCxnSpPr>
          <p:spPr>
            <a:xfrm>
              <a:off x="7561051" y="2672552"/>
              <a:ext cx="0" cy="145404"/>
            </a:xfrm>
            <a:prstGeom prst="line">
              <a:avLst/>
            </a:prstGeom>
            <a:ln w="38100">
              <a:solidFill>
                <a:srgbClr val="95C11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Straight Connector 77">
              <a:extLst>
                <a:ext uri="{FF2B5EF4-FFF2-40B4-BE49-F238E27FC236}">
                  <a16:creationId xmlns:a16="http://schemas.microsoft.com/office/drawing/2014/main" xmlns="" id="{A49D9843-D074-2439-8C71-C1335C6079AE}"/>
                </a:ext>
              </a:extLst>
            </p:cNvPr>
            <p:cNvCxnSpPr>
              <a:cxnSpLocks/>
            </p:cNvCxnSpPr>
            <p:nvPr/>
          </p:nvCxnSpPr>
          <p:spPr>
            <a:xfrm>
              <a:off x="7420667" y="2667898"/>
              <a:ext cx="0" cy="145404"/>
            </a:xfrm>
            <a:prstGeom prst="line">
              <a:avLst/>
            </a:prstGeom>
            <a:ln w="38100">
              <a:solidFill>
                <a:srgbClr val="95C11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0" name="Straight Arrow Connector 111">
              <a:extLst>
                <a:ext uri="{FF2B5EF4-FFF2-40B4-BE49-F238E27FC236}">
                  <a16:creationId xmlns:a16="http://schemas.microsoft.com/office/drawing/2014/main" xmlns="" id="{14EBB0D9-0D8B-347A-1BDA-CC3B6D6C0A48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8570471" y="3551526"/>
              <a:ext cx="361066" cy="170929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3" name="Oval 19">
              <a:extLst>
                <a:ext uri="{FF2B5EF4-FFF2-40B4-BE49-F238E27FC236}">
                  <a16:creationId xmlns:a16="http://schemas.microsoft.com/office/drawing/2014/main" xmlns="" id="{E09503D2-88BB-B659-4ADE-1E9C0D31D7EB}"/>
                </a:ext>
              </a:extLst>
            </p:cNvPr>
            <p:cNvSpPr/>
            <p:nvPr/>
          </p:nvSpPr>
          <p:spPr>
            <a:xfrm>
              <a:off x="7946325" y="1629629"/>
              <a:ext cx="427135" cy="930538"/>
            </a:xfrm>
            <a:prstGeom prst="ellipse">
              <a:avLst/>
            </a:prstGeom>
            <a:solidFill>
              <a:srgbClr val="FF6600"/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  <a:softEdge rad="12700"/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x-none" sz="1600">
                <a:cs typeface="Arial" panose="020B0604020202020204" pitchFamily="34" charset="0"/>
              </a:endParaRPr>
            </a:p>
          </p:txBody>
        </p:sp>
        <p:sp>
          <p:nvSpPr>
            <p:cNvPr id="114" name="Oval 19">
              <a:extLst>
                <a:ext uri="{FF2B5EF4-FFF2-40B4-BE49-F238E27FC236}">
                  <a16:creationId xmlns:a16="http://schemas.microsoft.com/office/drawing/2014/main" xmlns="" id="{E09503D2-88BB-B659-4ADE-1E9C0D31D7EB}"/>
                </a:ext>
              </a:extLst>
            </p:cNvPr>
            <p:cNvSpPr/>
            <p:nvPr/>
          </p:nvSpPr>
          <p:spPr>
            <a:xfrm>
              <a:off x="7674941" y="1629629"/>
              <a:ext cx="427135" cy="930538"/>
            </a:xfrm>
            <a:prstGeom prst="ellipse">
              <a:avLst/>
            </a:prstGeom>
            <a:solidFill>
              <a:srgbClr val="FF6600"/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  <a:softEdge rad="12700"/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x-none" sz="1600"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7544421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0</Words>
  <Application>Microsoft Office PowerPoint</Application>
  <PresentationFormat>Breitbild</PresentationFormat>
  <Paragraphs>2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5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7" baseType="lpstr">
      <vt:lpstr>宋体</vt:lpstr>
      <vt:lpstr>Arial</vt:lpstr>
      <vt:lpstr>Calibri</vt:lpstr>
      <vt:lpstr>Calibri Light</vt:lpstr>
      <vt:lpstr>等线</vt:lpstr>
      <vt:lpstr>Office Theme</vt:lpstr>
      <vt:lpstr>PowerPoint-Prä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arl-Wilhelm Koch</dc:creator>
  <cp:lastModifiedBy>Karl-Wilhelm Koch</cp:lastModifiedBy>
  <cp:revision>11</cp:revision>
  <dcterms:created xsi:type="dcterms:W3CDTF">2022-10-19T12:01:30Z</dcterms:created>
  <dcterms:modified xsi:type="dcterms:W3CDTF">2022-10-20T10:54:46Z</dcterms:modified>
</cp:coreProperties>
</file>